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401" r:id="rId2"/>
    <p:sldId id="362" r:id="rId3"/>
    <p:sldId id="404" r:id="rId4"/>
    <p:sldId id="407" r:id="rId5"/>
    <p:sldId id="408" r:id="rId6"/>
    <p:sldId id="388" r:id="rId7"/>
    <p:sldId id="409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858E187-86E0-4B67-9D23-C5381C2891CC}" v="5" dt="2025-12-01T14:29:40.349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5226" autoAdjust="0"/>
  </p:normalViewPr>
  <p:slideViewPr>
    <p:cSldViewPr snapToGrid="0">
      <p:cViewPr varScale="1">
        <p:scale>
          <a:sx n="104" d="100"/>
          <a:sy n="104" d="100"/>
        </p:scale>
        <p:origin x="174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Relationship Id="rId14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coville, David (NIH/NIEHS) [E]" userId="18f7fb2b-fdd1-4682-8a0d-ccc1081cf1bd" providerId="ADAL" clId="{9B5A2C7F-9EA0-4067-AD55-753D3A64C838}"/>
    <pc:docChg chg="custSel delSld modSld">
      <pc:chgData name="Scoville, David (NIH/NIEHS) [E]" userId="18f7fb2b-fdd1-4682-8a0d-ccc1081cf1bd" providerId="ADAL" clId="{9B5A2C7F-9EA0-4067-AD55-753D3A64C838}" dt="2025-09-05T20:42:01.529" v="24" actId="166"/>
      <pc:docMkLst>
        <pc:docMk/>
      </pc:docMkLst>
      <pc:sldChg chg="addSp delSp modSp mod">
        <pc:chgData name="Scoville, David (NIH/NIEHS) [E]" userId="18f7fb2b-fdd1-4682-8a0d-ccc1081cf1bd" providerId="ADAL" clId="{9B5A2C7F-9EA0-4067-AD55-753D3A64C838}" dt="2025-09-05T20:42:01.529" v="24" actId="166"/>
        <pc:sldMkLst>
          <pc:docMk/>
          <pc:sldMk cId="3891281025" sldId="386"/>
        </pc:sldMkLst>
      </pc:sldChg>
      <pc:sldChg chg="modSp mod">
        <pc:chgData name="Scoville, David (NIH/NIEHS) [E]" userId="18f7fb2b-fdd1-4682-8a0d-ccc1081cf1bd" providerId="ADAL" clId="{9B5A2C7F-9EA0-4067-AD55-753D3A64C838}" dt="2025-09-05T20:41:32.531" v="23" actId="555"/>
        <pc:sldMkLst>
          <pc:docMk/>
          <pc:sldMk cId="3267687131" sldId="389"/>
        </pc:sldMkLst>
      </pc:sldChg>
      <pc:sldChg chg="modSp mod">
        <pc:chgData name="Scoville, David (NIH/NIEHS) [E]" userId="18f7fb2b-fdd1-4682-8a0d-ccc1081cf1bd" providerId="ADAL" clId="{9B5A2C7F-9EA0-4067-AD55-753D3A64C838}" dt="2025-09-04T12:58:03.828" v="10" actId="20577"/>
        <pc:sldMkLst>
          <pc:docMk/>
          <pc:sldMk cId="4162854330" sldId="401"/>
        </pc:sldMkLst>
        <pc:spChg chg="mod">
          <ac:chgData name="Scoville, David (NIH/NIEHS) [E]" userId="18f7fb2b-fdd1-4682-8a0d-ccc1081cf1bd" providerId="ADAL" clId="{9B5A2C7F-9EA0-4067-AD55-753D3A64C838}" dt="2025-09-04T12:58:03.828" v="10" actId="20577"/>
          <ac:spMkLst>
            <pc:docMk/>
            <pc:sldMk cId="4162854330" sldId="401"/>
            <ac:spMk id="4" creationId="{423982A4-8F4E-62C1-6956-0078A7F4094C}"/>
          </ac:spMkLst>
        </pc:spChg>
      </pc:sldChg>
      <pc:sldChg chg="modSp del mod">
        <pc:chgData name="Scoville, David (NIH/NIEHS) [E]" userId="18f7fb2b-fdd1-4682-8a0d-ccc1081cf1bd" providerId="ADAL" clId="{9B5A2C7F-9EA0-4067-AD55-753D3A64C838}" dt="2025-09-05T20:40:08.263" v="14" actId="47"/>
        <pc:sldMkLst>
          <pc:docMk/>
          <pc:sldMk cId="2375239511" sldId="410"/>
        </pc:sldMkLst>
      </pc:sldChg>
    </pc:docChg>
  </pc:docChgLst>
  <pc:docChgLst>
    <pc:chgData name="Scoville, David (NIH/NIEHS) [E]" userId="18f7fb2b-fdd1-4682-8a0d-ccc1081cf1bd" providerId="ADAL" clId="{43115243-BF91-4726-84A1-DF43C2F0B131}"/>
    <pc:docChg chg="modSld">
      <pc:chgData name="Scoville, David (NIH/NIEHS) [E]" userId="18f7fb2b-fdd1-4682-8a0d-ccc1081cf1bd" providerId="ADAL" clId="{43115243-BF91-4726-84A1-DF43C2F0B131}" dt="2025-08-11T15:41:59.080" v="1" actId="1076"/>
      <pc:docMkLst>
        <pc:docMk/>
      </pc:docMkLst>
      <pc:sldChg chg="modSp mod">
        <pc:chgData name="Scoville, David (NIH/NIEHS) [E]" userId="18f7fb2b-fdd1-4682-8a0d-ccc1081cf1bd" providerId="ADAL" clId="{43115243-BF91-4726-84A1-DF43C2F0B131}" dt="2025-08-11T15:41:59.080" v="1" actId="1076"/>
        <pc:sldMkLst>
          <pc:docMk/>
          <pc:sldMk cId="3891281025" sldId="386"/>
        </pc:sldMkLst>
      </pc:sldChg>
    </pc:docChg>
  </pc:docChgLst>
  <pc:docChgLst>
    <pc:chgData name="Scoville, David (NIH/NIEHS) [E]" userId="18f7fb2b-fdd1-4682-8a0d-ccc1081cf1bd" providerId="ADAL" clId="{2858E187-86E0-4B67-9D23-C5381C2891CC}"/>
    <pc:docChg chg="undo custSel delSld modSld">
      <pc:chgData name="Scoville, David (NIH/NIEHS) [E]" userId="18f7fb2b-fdd1-4682-8a0d-ccc1081cf1bd" providerId="ADAL" clId="{2858E187-86E0-4B67-9D23-C5381C2891CC}" dt="2025-12-01T14:31:07.175" v="461" actId="948"/>
      <pc:docMkLst>
        <pc:docMk/>
      </pc:docMkLst>
      <pc:sldChg chg="addSp modSp mod">
        <pc:chgData name="Scoville, David (NIH/NIEHS) [E]" userId="18f7fb2b-fdd1-4682-8a0d-ccc1081cf1bd" providerId="ADAL" clId="{2858E187-86E0-4B67-9D23-C5381C2891CC}" dt="2025-12-01T14:24:59.066" v="262" actId="1076"/>
        <pc:sldMkLst>
          <pc:docMk/>
          <pc:sldMk cId="3302397530" sldId="362"/>
        </pc:sldMkLst>
        <pc:spChg chg="mod ord">
          <ac:chgData name="Scoville, David (NIH/NIEHS) [E]" userId="18f7fb2b-fdd1-4682-8a0d-ccc1081cf1bd" providerId="ADAL" clId="{2858E187-86E0-4B67-9D23-C5381C2891CC}" dt="2025-12-01T14:24:14.945" v="230" actId="1036"/>
          <ac:spMkLst>
            <pc:docMk/>
            <pc:sldMk cId="3302397530" sldId="362"/>
            <ac:spMk id="2" creationId="{DF3F3BCE-17D3-AA11-B583-7C0CBB222E7C}"/>
          </ac:spMkLst>
        </pc:spChg>
        <pc:spChg chg="mod ord">
          <ac:chgData name="Scoville, David (NIH/NIEHS) [E]" userId="18f7fb2b-fdd1-4682-8a0d-ccc1081cf1bd" providerId="ADAL" clId="{2858E187-86E0-4B67-9D23-C5381C2891CC}" dt="2025-12-01T14:24:14.945" v="230" actId="1036"/>
          <ac:spMkLst>
            <pc:docMk/>
            <pc:sldMk cId="3302397530" sldId="362"/>
            <ac:spMk id="3" creationId="{4D63D17D-D93B-9B61-C595-B3EC61D1D695}"/>
          </ac:spMkLst>
        </pc:spChg>
        <pc:spChg chg="mod">
          <ac:chgData name="Scoville, David (NIH/NIEHS) [E]" userId="18f7fb2b-fdd1-4682-8a0d-ccc1081cf1bd" providerId="ADAL" clId="{2858E187-86E0-4B67-9D23-C5381C2891CC}" dt="2025-12-01T14:24:14.945" v="230" actId="1036"/>
          <ac:spMkLst>
            <pc:docMk/>
            <pc:sldMk cId="3302397530" sldId="362"/>
            <ac:spMk id="5" creationId="{321BE381-40E4-0471-BD3C-46F609EE5E7D}"/>
          </ac:spMkLst>
        </pc:spChg>
        <pc:spChg chg="mod">
          <ac:chgData name="Scoville, David (NIH/NIEHS) [E]" userId="18f7fb2b-fdd1-4682-8a0d-ccc1081cf1bd" providerId="ADAL" clId="{2858E187-86E0-4B67-9D23-C5381C2891CC}" dt="2025-12-01T14:21:45.310" v="142" actId="1076"/>
          <ac:spMkLst>
            <pc:docMk/>
            <pc:sldMk cId="3302397530" sldId="362"/>
            <ac:spMk id="6" creationId="{8867B836-FD31-D24F-80A2-9908B7BD9574}"/>
          </ac:spMkLst>
        </pc:spChg>
        <pc:spChg chg="mod">
          <ac:chgData name="Scoville, David (NIH/NIEHS) [E]" userId="18f7fb2b-fdd1-4682-8a0d-ccc1081cf1bd" providerId="ADAL" clId="{2858E187-86E0-4B67-9D23-C5381C2891CC}" dt="2025-12-01T14:24:14.945" v="230" actId="1036"/>
          <ac:spMkLst>
            <pc:docMk/>
            <pc:sldMk cId="3302397530" sldId="362"/>
            <ac:spMk id="7" creationId="{6CDEBA7C-F26F-89F5-6527-7927B8142BA2}"/>
          </ac:spMkLst>
        </pc:spChg>
        <pc:spChg chg="add mod">
          <ac:chgData name="Scoville, David (NIH/NIEHS) [E]" userId="18f7fb2b-fdd1-4682-8a0d-ccc1081cf1bd" providerId="ADAL" clId="{2858E187-86E0-4B67-9D23-C5381C2891CC}" dt="2025-12-01T14:24:48.213" v="254" actId="1035"/>
          <ac:spMkLst>
            <pc:docMk/>
            <pc:sldMk cId="3302397530" sldId="362"/>
            <ac:spMk id="9" creationId="{54C869CB-478F-182A-616A-50EAF5CFA7C5}"/>
          </ac:spMkLst>
        </pc:spChg>
        <pc:spChg chg="add mod ord">
          <ac:chgData name="Scoville, David (NIH/NIEHS) [E]" userId="18f7fb2b-fdd1-4682-8a0d-ccc1081cf1bd" providerId="ADAL" clId="{2858E187-86E0-4B67-9D23-C5381C2891CC}" dt="2025-12-01T14:24:14.945" v="230" actId="1036"/>
          <ac:spMkLst>
            <pc:docMk/>
            <pc:sldMk cId="3302397530" sldId="362"/>
            <ac:spMk id="11" creationId="{35F8C6B3-A8F6-BC95-6CA3-83928D540993}"/>
          </ac:spMkLst>
        </pc:spChg>
        <pc:spChg chg="add mod">
          <ac:chgData name="Scoville, David (NIH/NIEHS) [E]" userId="18f7fb2b-fdd1-4682-8a0d-ccc1081cf1bd" providerId="ADAL" clId="{2858E187-86E0-4B67-9D23-C5381C2891CC}" dt="2025-12-01T14:24:14.945" v="230" actId="1036"/>
          <ac:spMkLst>
            <pc:docMk/>
            <pc:sldMk cId="3302397530" sldId="362"/>
            <ac:spMk id="12" creationId="{E032E14B-1AAF-8983-A9AE-27BF847CE8C5}"/>
          </ac:spMkLst>
        </pc:spChg>
        <pc:spChg chg="add mod">
          <ac:chgData name="Scoville, David (NIH/NIEHS) [E]" userId="18f7fb2b-fdd1-4682-8a0d-ccc1081cf1bd" providerId="ADAL" clId="{2858E187-86E0-4B67-9D23-C5381C2891CC}" dt="2025-12-01T14:24:59.066" v="262" actId="1076"/>
          <ac:spMkLst>
            <pc:docMk/>
            <pc:sldMk cId="3302397530" sldId="362"/>
            <ac:spMk id="14" creationId="{83ABB738-BC51-4100-70DD-C2242782D71C}"/>
          </ac:spMkLst>
        </pc:spChg>
        <pc:picChg chg="mod">
          <ac:chgData name="Scoville, David (NIH/NIEHS) [E]" userId="18f7fb2b-fdd1-4682-8a0d-ccc1081cf1bd" providerId="ADAL" clId="{2858E187-86E0-4B67-9D23-C5381C2891CC}" dt="2025-12-01T14:24:14.945" v="230" actId="1036"/>
          <ac:picMkLst>
            <pc:docMk/>
            <pc:sldMk cId="3302397530" sldId="362"/>
            <ac:picMk id="4" creationId="{29FC1CEB-3F25-012B-66F5-C16D498D8527}"/>
          </ac:picMkLst>
        </pc:picChg>
        <pc:picChg chg="add mod">
          <ac:chgData name="Scoville, David (NIH/NIEHS) [E]" userId="18f7fb2b-fdd1-4682-8a0d-ccc1081cf1bd" providerId="ADAL" clId="{2858E187-86E0-4B67-9D23-C5381C2891CC}" dt="2025-12-01T14:24:14.945" v="230" actId="1036"/>
          <ac:picMkLst>
            <pc:docMk/>
            <pc:sldMk cId="3302397530" sldId="362"/>
            <ac:picMk id="10" creationId="{8B201E7C-D456-5C47-ECAC-833AE85637B5}"/>
          </ac:picMkLst>
        </pc:picChg>
        <pc:picChg chg="add mod">
          <ac:chgData name="Scoville, David (NIH/NIEHS) [E]" userId="18f7fb2b-fdd1-4682-8a0d-ccc1081cf1bd" providerId="ADAL" clId="{2858E187-86E0-4B67-9D23-C5381C2891CC}" dt="2025-12-01T14:24:52.706" v="261" actId="1036"/>
          <ac:picMkLst>
            <pc:docMk/>
            <pc:sldMk cId="3302397530" sldId="362"/>
            <ac:picMk id="13" creationId="{6A391E81-6FAD-225F-3D36-68A302B39D06}"/>
          </ac:picMkLst>
        </pc:picChg>
        <pc:picChg chg="mod">
          <ac:chgData name="Scoville, David (NIH/NIEHS) [E]" userId="18f7fb2b-fdd1-4682-8a0d-ccc1081cf1bd" providerId="ADAL" clId="{2858E187-86E0-4B67-9D23-C5381C2891CC}" dt="2025-12-01T14:24:14.945" v="230" actId="1036"/>
          <ac:picMkLst>
            <pc:docMk/>
            <pc:sldMk cId="3302397530" sldId="362"/>
            <ac:picMk id="16" creationId="{1713FB96-CC59-EF79-6BAB-2A8B2F6BC8B5}"/>
          </ac:picMkLst>
        </pc:picChg>
      </pc:sldChg>
      <pc:sldChg chg="del">
        <pc:chgData name="Scoville, David (NIH/NIEHS) [E]" userId="18f7fb2b-fdd1-4682-8a0d-ccc1081cf1bd" providerId="ADAL" clId="{2858E187-86E0-4B67-9D23-C5381C2891CC}" dt="2025-12-01T14:25:06.206" v="263" actId="47"/>
        <pc:sldMkLst>
          <pc:docMk/>
          <pc:sldMk cId="3891281025" sldId="386"/>
        </pc:sldMkLst>
      </pc:sldChg>
      <pc:sldChg chg="addSp modSp mod">
        <pc:chgData name="Scoville, David (NIH/NIEHS) [E]" userId="18f7fb2b-fdd1-4682-8a0d-ccc1081cf1bd" providerId="ADAL" clId="{2858E187-86E0-4B67-9D23-C5381C2891CC}" dt="2025-12-01T14:30:45.036" v="454" actId="1035"/>
        <pc:sldMkLst>
          <pc:docMk/>
          <pc:sldMk cId="248345497" sldId="388"/>
        </pc:sldMkLst>
        <pc:spChg chg="mod">
          <ac:chgData name="Scoville, David (NIH/NIEHS) [E]" userId="18f7fb2b-fdd1-4682-8a0d-ccc1081cf1bd" providerId="ADAL" clId="{2858E187-86E0-4B67-9D23-C5381C2891CC}" dt="2025-12-01T14:27:58.084" v="348" actId="1076"/>
          <ac:spMkLst>
            <pc:docMk/>
            <pc:sldMk cId="248345497" sldId="388"/>
            <ac:spMk id="4" creationId="{097E109A-719D-38D0-6C94-EE1A79580E63}"/>
          </ac:spMkLst>
        </pc:spChg>
        <pc:spChg chg="mod">
          <ac:chgData name="Scoville, David (NIH/NIEHS) [E]" userId="18f7fb2b-fdd1-4682-8a0d-ccc1081cf1bd" providerId="ADAL" clId="{2858E187-86E0-4B67-9D23-C5381C2891CC}" dt="2025-12-01T14:27:50.502" v="347" actId="1076"/>
          <ac:spMkLst>
            <pc:docMk/>
            <pc:sldMk cId="248345497" sldId="388"/>
            <ac:spMk id="7" creationId="{0861D1E3-E869-C2B0-0F29-A05EFA2A6E3D}"/>
          </ac:spMkLst>
        </pc:spChg>
        <pc:spChg chg="mod">
          <ac:chgData name="Scoville, David (NIH/NIEHS) [E]" userId="18f7fb2b-fdd1-4682-8a0d-ccc1081cf1bd" providerId="ADAL" clId="{2858E187-86E0-4B67-9D23-C5381C2891CC}" dt="2025-12-01T14:27:46.809" v="346" actId="1076"/>
          <ac:spMkLst>
            <pc:docMk/>
            <pc:sldMk cId="248345497" sldId="388"/>
            <ac:spMk id="11" creationId="{49B95C1F-F5BD-FB49-5706-3EEAC7E3DE4F}"/>
          </ac:spMkLst>
        </pc:spChg>
        <pc:spChg chg="add mod">
          <ac:chgData name="Scoville, David (NIH/NIEHS) [E]" userId="18f7fb2b-fdd1-4682-8a0d-ccc1081cf1bd" providerId="ADAL" clId="{2858E187-86E0-4B67-9D23-C5381C2891CC}" dt="2025-12-01T14:30:45.036" v="454" actId="1035"/>
          <ac:spMkLst>
            <pc:docMk/>
            <pc:sldMk cId="248345497" sldId="388"/>
            <ac:spMk id="12" creationId="{2D558487-B285-3284-7BF0-A6C5B1F3BD73}"/>
          </ac:spMkLst>
        </pc:spChg>
        <pc:spChg chg="add mod">
          <ac:chgData name="Scoville, David (NIH/NIEHS) [E]" userId="18f7fb2b-fdd1-4682-8a0d-ccc1081cf1bd" providerId="ADAL" clId="{2858E187-86E0-4B67-9D23-C5381C2891CC}" dt="2025-12-01T14:30:45.036" v="454" actId="1035"/>
          <ac:spMkLst>
            <pc:docMk/>
            <pc:sldMk cId="248345497" sldId="388"/>
            <ac:spMk id="13" creationId="{FB8D6822-5A13-1354-C7C9-4401233CCAD2}"/>
          </ac:spMkLst>
        </pc:spChg>
        <pc:spChg chg="add mod">
          <ac:chgData name="Scoville, David (NIH/NIEHS) [E]" userId="18f7fb2b-fdd1-4682-8a0d-ccc1081cf1bd" providerId="ADAL" clId="{2858E187-86E0-4B67-9D23-C5381C2891CC}" dt="2025-12-01T14:30:45.036" v="454" actId="1035"/>
          <ac:spMkLst>
            <pc:docMk/>
            <pc:sldMk cId="248345497" sldId="388"/>
            <ac:spMk id="15" creationId="{9CEEAB98-0AF7-D9FA-CCB4-AEC8C2D6EDE5}"/>
          </ac:spMkLst>
        </pc:spChg>
        <pc:spChg chg="mod">
          <ac:chgData name="Scoville, David (NIH/NIEHS) [E]" userId="18f7fb2b-fdd1-4682-8a0d-ccc1081cf1bd" providerId="ADAL" clId="{2858E187-86E0-4B67-9D23-C5381C2891CC}" dt="2025-12-01T14:30:45.036" v="454" actId="1035"/>
          <ac:spMkLst>
            <pc:docMk/>
            <pc:sldMk cId="248345497" sldId="388"/>
            <ac:spMk id="19" creationId="{2D558487-B285-3284-7BF0-A6C5B1F3BD73}"/>
          </ac:spMkLst>
        </pc:spChg>
        <pc:grpChg chg="mod">
          <ac:chgData name="Scoville, David (NIH/NIEHS) [E]" userId="18f7fb2b-fdd1-4682-8a0d-ccc1081cf1bd" providerId="ADAL" clId="{2858E187-86E0-4B67-9D23-C5381C2891CC}" dt="2025-12-01T14:30:45.036" v="454" actId="1035"/>
          <ac:grpSpMkLst>
            <pc:docMk/>
            <pc:sldMk cId="248345497" sldId="388"/>
            <ac:grpSpMk id="5" creationId="{0284AA9F-1F0E-893F-CC0A-2310C09C5841}"/>
          </ac:grpSpMkLst>
        </pc:grpChg>
        <pc:grpChg chg="add mod">
          <ac:chgData name="Scoville, David (NIH/NIEHS) [E]" userId="18f7fb2b-fdd1-4682-8a0d-ccc1081cf1bd" providerId="ADAL" clId="{2858E187-86E0-4B67-9D23-C5381C2891CC}" dt="2025-12-01T14:30:45.036" v="454" actId="1035"/>
          <ac:grpSpMkLst>
            <pc:docMk/>
            <pc:sldMk cId="248345497" sldId="388"/>
            <ac:grpSpMk id="8" creationId="{5A3B56B0-41FB-8DC9-BA60-CB3ACAA8DBDE}"/>
          </ac:grpSpMkLst>
        </pc:grpChg>
        <pc:grpChg chg="add mod">
          <ac:chgData name="Scoville, David (NIH/NIEHS) [E]" userId="18f7fb2b-fdd1-4682-8a0d-ccc1081cf1bd" providerId="ADAL" clId="{2858E187-86E0-4B67-9D23-C5381C2891CC}" dt="2025-12-01T14:30:45.036" v="454" actId="1035"/>
          <ac:grpSpMkLst>
            <pc:docMk/>
            <pc:sldMk cId="248345497" sldId="388"/>
            <ac:grpSpMk id="9" creationId="{8E5CCBAE-1397-7C0F-7E68-FF33C408A341}"/>
          </ac:grpSpMkLst>
        </pc:grpChg>
        <pc:picChg chg="mod modCrop">
          <ac:chgData name="Scoville, David (NIH/NIEHS) [E]" userId="18f7fb2b-fdd1-4682-8a0d-ccc1081cf1bd" providerId="ADAL" clId="{2858E187-86E0-4B67-9D23-C5381C2891CC}" dt="2025-12-01T14:26:25.479" v="281" actId="732"/>
          <ac:picMkLst>
            <pc:docMk/>
            <pc:sldMk cId="248345497" sldId="388"/>
            <ac:picMk id="3" creationId="{C60781D6-EAD1-EDDC-FC6E-41A2ADA93167}"/>
          </ac:picMkLst>
        </pc:picChg>
        <pc:picChg chg="mod">
          <ac:chgData name="Scoville, David (NIH/NIEHS) [E]" userId="18f7fb2b-fdd1-4682-8a0d-ccc1081cf1bd" providerId="ADAL" clId="{2858E187-86E0-4B67-9D23-C5381C2891CC}" dt="2025-12-01T14:25:25.065" v="265"/>
          <ac:picMkLst>
            <pc:docMk/>
            <pc:sldMk cId="248345497" sldId="388"/>
            <ac:picMk id="6" creationId="{2B04E548-BDF9-857D-2956-5406BC707926}"/>
          </ac:picMkLst>
        </pc:picChg>
        <pc:picChg chg="mod">
          <ac:chgData name="Scoville, David (NIH/NIEHS) [E]" userId="18f7fb2b-fdd1-4682-8a0d-ccc1081cf1bd" providerId="ADAL" clId="{2858E187-86E0-4B67-9D23-C5381C2891CC}" dt="2025-12-01T14:25:25.065" v="265"/>
          <ac:picMkLst>
            <pc:docMk/>
            <pc:sldMk cId="248345497" sldId="388"/>
            <ac:picMk id="10" creationId="{0A8C3519-559B-24AF-D293-879FCBBE5883}"/>
          </ac:picMkLst>
        </pc:picChg>
      </pc:sldChg>
      <pc:sldChg chg="delSp del mod">
        <pc:chgData name="Scoville, David (NIH/NIEHS) [E]" userId="18f7fb2b-fdd1-4682-8a0d-ccc1081cf1bd" providerId="ADAL" clId="{2858E187-86E0-4B67-9D23-C5381C2891CC}" dt="2025-12-01T14:28:02.542" v="349" actId="47"/>
        <pc:sldMkLst>
          <pc:docMk/>
          <pc:sldMk cId="3267687131" sldId="389"/>
        </pc:sldMkLst>
        <pc:spChg chg="del">
          <ac:chgData name="Scoville, David (NIH/NIEHS) [E]" userId="18f7fb2b-fdd1-4682-8a0d-ccc1081cf1bd" providerId="ADAL" clId="{2858E187-86E0-4B67-9D23-C5381C2891CC}" dt="2025-12-01T14:25:24.138" v="264" actId="21"/>
          <ac:spMkLst>
            <pc:docMk/>
            <pc:sldMk cId="3267687131" sldId="389"/>
            <ac:spMk id="6" creationId="{FB8D6822-5A13-1354-C7C9-4401233CCAD2}"/>
          </ac:spMkLst>
        </pc:spChg>
        <pc:spChg chg="del">
          <ac:chgData name="Scoville, David (NIH/NIEHS) [E]" userId="18f7fb2b-fdd1-4682-8a0d-ccc1081cf1bd" providerId="ADAL" clId="{2858E187-86E0-4B67-9D23-C5381C2891CC}" dt="2025-12-01T14:25:24.138" v="264" actId="21"/>
          <ac:spMkLst>
            <pc:docMk/>
            <pc:sldMk cId="3267687131" sldId="389"/>
            <ac:spMk id="19" creationId="{2D558487-B285-3284-7BF0-A6C5B1F3BD73}"/>
          </ac:spMkLst>
        </pc:spChg>
        <pc:grpChg chg="del">
          <ac:chgData name="Scoville, David (NIH/NIEHS) [E]" userId="18f7fb2b-fdd1-4682-8a0d-ccc1081cf1bd" providerId="ADAL" clId="{2858E187-86E0-4B67-9D23-C5381C2891CC}" dt="2025-12-01T14:25:24.138" v="264" actId="21"/>
          <ac:grpSpMkLst>
            <pc:docMk/>
            <pc:sldMk cId="3267687131" sldId="389"/>
            <ac:grpSpMk id="8" creationId="{5A3B56B0-41FB-8DC9-BA60-CB3ACAA8DBDE}"/>
          </ac:grpSpMkLst>
        </pc:grpChg>
        <pc:grpChg chg="del">
          <ac:chgData name="Scoville, David (NIH/NIEHS) [E]" userId="18f7fb2b-fdd1-4682-8a0d-ccc1081cf1bd" providerId="ADAL" clId="{2858E187-86E0-4B67-9D23-C5381C2891CC}" dt="2025-12-01T14:25:24.138" v="264" actId="21"/>
          <ac:grpSpMkLst>
            <pc:docMk/>
            <pc:sldMk cId="3267687131" sldId="389"/>
            <ac:grpSpMk id="9" creationId="{8E5CCBAE-1397-7C0F-7E68-FF33C408A341}"/>
          </ac:grpSpMkLst>
        </pc:grpChg>
      </pc:sldChg>
      <pc:sldChg chg="modSp del mod">
        <pc:chgData name="Scoville, David (NIH/NIEHS) [E]" userId="18f7fb2b-fdd1-4682-8a0d-ccc1081cf1bd" providerId="ADAL" clId="{2858E187-86E0-4B67-9D23-C5381C2891CC}" dt="2025-12-01T14:23:46.743" v="209" actId="47"/>
        <pc:sldMkLst>
          <pc:docMk/>
          <pc:sldMk cId="3019216763" sldId="392"/>
        </pc:sldMkLst>
        <pc:spChg chg="mod ord">
          <ac:chgData name="Scoville, David (NIH/NIEHS) [E]" userId="18f7fb2b-fdd1-4682-8a0d-ccc1081cf1bd" providerId="ADAL" clId="{2858E187-86E0-4B67-9D23-C5381C2891CC}" dt="2025-12-01T14:20:23.053" v="130" actId="1035"/>
          <ac:spMkLst>
            <pc:docMk/>
            <pc:sldMk cId="3019216763" sldId="392"/>
            <ac:spMk id="5" creationId="{525741FE-CF77-1453-D161-8E32D2EE1173}"/>
          </ac:spMkLst>
        </pc:spChg>
        <pc:spChg chg="mod ord">
          <ac:chgData name="Scoville, David (NIH/NIEHS) [E]" userId="18f7fb2b-fdd1-4682-8a0d-ccc1081cf1bd" providerId="ADAL" clId="{2858E187-86E0-4B67-9D23-C5381C2891CC}" dt="2025-12-01T14:20:23.053" v="130" actId="1035"/>
          <ac:spMkLst>
            <pc:docMk/>
            <pc:sldMk cId="3019216763" sldId="392"/>
            <ac:spMk id="6" creationId="{9E3EB167-895C-4796-0B11-0B89739A90DA}"/>
          </ac:spMkLst>
        </pc:spChg>
        <pc:picChg chg="mod">
          <ac:chgData name="Scoville, David (NIH/NIEHS) [E]" userId="18f7fb2b-fdd1-4682-8a0d-ccc1081cf1bd" providerId="ADAL" clId="{2858E187-86E0-4B67-9D23-C5381C2891CC}" dt="2025-12-01T14:20:23.053" v="130" actId="1035"/>
          <ac:picMkLst>
            <pc:docMk/>
            <pc:sldMk cId="3019216763" sldId="392"/>
            <ac:picMk id="2" creationId="{E93B767A-04C8-ADF1-020C-642D5EE4E341}"/>
          </ac:picMkLst>
        </pc:picChg>
      </pc:sldChg>
      <pc:sldChg chg="addSp modSp mod">
        <pc:chgData name="Scoville, David (NIH/NIEHS) [E]" userId="18f7fb2b-fdd1-4682-8a0d-ccc1081cf1bd" providerId="ADAL" clId="{2858E187-86E0-4B67-9D23-C5381C2891CC}" dt="2025-12-01T14:28:53.021" v="361" actId="404"/>
        <pc:sldMkLst>
          <pc:docMk/>
          <pc:sldMk cId="4162854330" sldId="401"/>
        </pc:sldMkLst>
        <pc:spChg chg="add mod">
          <ac:chgData name="Scoville, David (NIH/NIEHS) [E]" userId="18f7fb2b-fdd1-4682-8a0d-ccc1081cf1bd" providerId="ADAL" clId="{2858E187-86E0-4B67-9D23-C5381C2891CC}" dt="2025-12-01T14:18:34.673" v="7" actId="404"/>
          <ac:spMkLst>
            <pc:docMk/>
            <pc:sldMk cId="4162854330" sldId="401"/>
            <ac:spMk id="5" creationId="{C232BE77-78C8-8335-A665-D49DBCB2C290}"/>
          </ac:spMkLst>
        </pc:spChg>
        <pc:spChg chg="mod">
          <ac:chgData name="Scoville, David (NIH/NIEHS) [E]" userId="18f7fb2b-fdd1-4682-8a0d-ccc1081cf1bd" providerId="ADAL" clId="{2858E187-86E0-4B67-9D23-C5381C2891CC}" dt="2025-12-01T14:28:53.021" v="361" actId="404"/>
          <ac:spMkLst>
            <pc:docMk/>
            <pc:sldMk cId="4162854330" sldId="401"/>
            <ac:spMk id="8" creationId="{3800E4BD-3A19-82B8-A363-A25DA5AC1CEA}"/>
          </ac:spMkLst>
        </pc:spChg>
        <pc:spChg chg="mod">
          <ac:chgData name="Scoville, David (NIH/NIEHS) [E]" userId="18f7fb2b-fdd1-4682-8a0d-ccc1081cf1bd" providerId="ADAL" clId="{2858E187-86E0-4B67-9D23-C5381C2891CC}" dt="2025-12-01T14:28:53.021" v="361" actId="404"/>
          <ac:spMkLst>
            <pc:docMk/>
            <pc:sldMk cId="4162854330" sldId="401"/>
            <ac:spMk id="9" creationId="{F0A1AB7D-15B3-31F0-861D-46F02A4DFC87}"/>
          </ac:spMkLst>
        </pc:spChg>
      </pc:sldChg>
      <pc:sldChg chg="addSp modSp mod">
        <pc:chgData name="Scoville, David (NIH/NIEHS) [E]" userId="18f7fb2b-fdd1-4682-8a0d-ccc1081cf1bd" providerId="ADAL" clId="{2858E187-86E0-4B67-9D23-C5381C2891CC}" dt="2025-12-01T14:28:44.416" v="359" actId="404"/>
        <pc:sldMkLst>
          <pc:docMk/>
          <pc:sldMk cId="2222071772" sldId="404"/>
        </pc:sldMkLst>
        <pc:spChg chg="add mod">
          <ac:chgData name="Scoville, David (NIH/NIEHS) [E]" userId="18f7fb2b-fdd1-4682-8a0d-ccc1081cf1bd" providerId="ADAL" clId="{2858E187-86E0-4B67-9D23-C5381C2891CC}" dt="2025-12-01T14:28:31.786" v="357" actId="1076"/>
          <ac:spMkLst>
            <pc:docMk/>
            <pc:sldMk cId="2222071772" sldId="404"/>
            <ac:spMk id="5" creationId="{3FB241CB-51CD-D5C1-3FA2-1DDE0455C93D}"/>
          </ac:spMkLst>
        </pc:spChg>
        <pc:spChg chg="mod">
          <ac:chgData name="Scoville, David (NIH/NIEHS) [E]" userId="18f7fb2b-fdd1-4682-8a0d-ccc1081cf1bd" providerId="ADAL" clId="{2858E187-86E0-4B67-9D23-C5381C2891CC}" dt="2025-12-01T14:28:44.416" v="359" actId="404"/>
          <ac:spMkLst>
            <pc:docMk/>
            <pc:sldMk cId="2222071772" sldId="404"/>
            <ac:spMk id="9" creationId="{3682E5CF-903B-35C9-DD54-625732C30B5B}"/>
          </ac:spMkLst>
        </pc:spChg>
        <pc:spChg chg="mod">
          <ac:chgData name="Scoville, David (NIH/NIEHS) [E]" userId="18f7fb2b-fdd1-4682-8a0d-ccc1081cf1bd" providerId="ADAL" clId="{2858E187-86E0-4B67-9D23-C5381C2891CC}" dt="2025-12-01T14:28:44.416" v="359" actId="404"/>
          <ac:spMkLst>
            <pc:docMk/>
            <pc:sldMk cId="2222071772" sldId="404"/>
            <ac:spMk id="10" creationId="{2D6E4C38-562C-A635-916B-FE52AF84C1E5}"/>
          </ac:spMkLst>
        </pc:spChg>
        <pc:spChg chg="mod">
          <ac:chgData name="Scoville, David (NIH/NIEHS) [E]" userId="18f7fb2b-fdd1-4682-8a0d-ccc1081cf1bd" providerId="ADAL" clId="{2858E187-86E0-4B67-9D23-C5381C2891CC}" dt="2025-12-01T14:28:44.416" v="359" actId="404"/>
          <ac:spMkLst>
            <pc:docMk/>
            <pc:sldMk cId="2222071772" sldId="404"/>
            <ac:spMk id="11" creationId="{665ED850-5258-73D0-D72A-C8A928F90963}"/>
          </ac:spMkLst>
        </pc:spChg>
      </pc:sldChg>
      <pc:sldChg chg="addSp modSp mod">
        <pc:chgData name="Scoville, David (NIH/NIEHS) [E]" userId="18f7fb2b-fdd1-4682-8a0d-ccc1081cf1bd" providerId="ADAL" clId="{2858E187-86E0-4B67-9D23-C5381C2891CC}" dt="2025-12-01T14:29:28.904" v="388" actId="1035"/>
        <pc:sldMkLst>
          <pc:docMk/>
          <pc:sldMk cId="1574866281" sldId="407"/>
        </pc:sldMkLst>
        <pc:spChg chg="add mod">
          <ac:chgData name="Scoville, David (NIH/NIEHS) [E]" userId="18f7fb2b-fdd1-4682-8a0d-ccc1081cf1bd" providerId="ADAL" clId="{2858E187-86E0-4B67-9D23-C5381C2891CC}" dt="2025-12-01T14:29:28.904" v="388" actId="1035"/>
          <ac:spMkLst>
            <pc:docMk/>
            <pc:sldMk cId="1574866281" sldId="407"/>
            <ac:spMk id="4" creationId="{4F2815F6-B28E-0A95-1444-2492F4007ECC}"/>
          </ac:spMkLst>
        </pc:spChg>
        <pc:spChg chg="mod">
          <ac:chgData name="Scoville, David (NIH/NIEHS) [E]" userId="18f7fb2b-fdd1-4682-8a0d-ccc1081cf1bd" providerId="ADAL" clId="{2858E187-86E0-4B67-9D23-C5381C2891CC}" dt="2025-12-01T14:29:28.904" v="388" actId="1035"/>
          <ac:spMkLst>
            <pc:docMk/>
            <pc:sldMk cId="1574866281" sldId="407"/>
            <ac:spMk id="10" creationId="{7248F7B3-B1AF-B045-CC61-E5851660B579}"/>
          </ac:spMkLst>
        </pc:spChg>
        <pc:spChg chg="mod">
          <ac:chgData name="Scoville, David (NIH/NIEHS) [E]" userId="18f7fb2b-fdd1-4682-8a0d-ccc1081cf1bd" providerId="ADAL" clId="{2858E187-86E0-4B67-9D23-C5381C2891CC}" dt="2025-12-01T14:29:28.904" v="388" actId="1035"/>
          <ac:spMkLst>
            <pc:docMk/>
            <pc:sldMk cId="1574866281" sldId="407"/>
            <ac:spMk id="11" creationId="{2EE97088-EF7C-9486-ECD6-6AB6E3EC0738}"/>
          </ac:spMkLst>
        </pc:spChg>
        <pc:spChg chg="mod">
          <ac:chgData name="Scoville, David (NIH/NIEHS) [E]" userId="18f7fb2b-fdd1-4682-8a0d-ccc1081cf1bd" providerId="ADAL" clId="{2858E187-86E0-4B67-9D23-C5381C2891CC}" dt="2025-12-01T14:29:28.904" v="388" actId="1035"/>
          <ac:spMkLst>
            <pc:docMk/>
            <pc:sldMk cId="1574866281" sldId="407"/>
            <ac:spMk id="19" creationId="{2D558487-B285-3284-7BF0-A6C5B1F3BD73}"/>
          </ac:spMkLst>
        </pc:spChg>
        <pc:grpChg chg="mod">
          <ac:chgData name="Scoville, David (NIH/NIEHS) [E]" userId="18f7fb2b-fdd1-4682-8a0d-ccc1081cf1bd" providerId="ADAL" clId="{2858E187-86E0-4B67-9D23-C5381C2891CC}" dt="2025-12-01T14:29:28.904" v="388" actId="1035"/>
          <ac:grpSpMkLst>
            <pc:docMk/>
            <pc:sldMk cId="1574866281" sldId="407"/>
            <ac:grpSpMk id="16" creationId="{F8735F88-643E-70DF-DF5E-AEE187FE1E13}"/>
          </ac:grpSpMkLst>
        </pc:grpChg>
        <pc:grpChg chg="mod">
          <ac:chgData name="Scoville, David (NIH/NIEHS) [E]" userId="18f7fb2b-fdd1-4682-8a0d-ccc1081cf1bd" providerId="ADAL" clId="{2858E187-86E0-4B67-9D23-C5381C2891CC}" dt="2025-12-01T14:29:28.904" v="388" actId="1035"/>
          <ac:grpSpMkLst>
            <pc:docMk/>
            <pc:sldMk cId="1574866281" sldId="407"/>
            <ac:grpSpMk id="17" creationId="{96A2F24D-B5E6-9F07-0B00-6B3019C14450}"/>
          </ac:grpSpMkLst>
        </pc:grpChg>
        <pc:grpChg chg="mod">
          <ac:chgData name="Scoville, David (NIH/NIEHS) [E]" userId="18f7fb2b-fdd1-4682-8a0d-ccc1081cf1bd" providerId="ADAL" clId="{2858E187-86E0-4B67-9D23-C5381C2891CC}" dt="2025-12-01T14:29:28.904" v="388" actId="1035"/>
          <ac:grpSpMkLst>
            <pc:docMk/>
            <pc:sldMk cId="1574866281" sldId="407"/>
            <ac:grpSpMk id="18" creationId="{0737DF2F-BC37-3ED9-AB4E-84191437642B}"/>
          </ac:grpSpMkLst>
        </pc:grpChg>
      </pc:sldChg>
      <pc:sldChg chg="addSp modSp mod">
        <pc:chgData name="Scoville, David (NIH/NIEHS) [E]" userId="18f7fb2b-fdd1-4682-8a0d-ccc1081cf1bd" providerId="ADAL" clId="{2858E187-86E0-4B67-9D23-C5381C2891CC}" dt="2025-12-01T14:30:14.039" v="412" actId="1076"/>
        <pc:sldMkLst>
          <pc:docMk/>
          <pc:sldMk cId="3706520726" sldId="408"/>
        </pc:sldMkLst>
        <pc:spChg chg="mod">
          <ac:chgData name="Scoville, David (NIH/NIEHS) [E]" userId="18f7fb2b-fdd1-4682-8a0d-ccc1081cf1bd" providerId="ADAL" clId="{2858E187-86E0-4B67-9D23-C5381C2891CC}" dt="2025-12-01T14:29:49.206" v="404" actId="1037"/>
          <ac:spMkLst>
            <pc:docMk/>
            <pc:sldMk cId="3706520726" sldId="408"/>
            <ac:spMk id="5" creationId="{6874B5C2-C011-2F1D-C0AD-DC57F5AC1D55}"/>
          </ac:spMkLst>
        </pc:spChg>
        <pc:spChg chg="add mod">
          <ac:chgData name="Scoville, David (NIH/NIEHS) [E]" userId="18f7fb2b-fdd1-4682-8a0d-ccc1081cf1bd" providerId="ADAL" clId="{2858E187-86E0-4B67-9D23-C5381C2891CC}" dt="2025-12-01T14:30:14.039" v="412" actId="1076"/>
          <ac:spMkLst>
            <pc:docMk/>
            <pc:sldMk cId="3706520726" sldId="408"/>
            <ac:spMk id="7" creationId="{7922FF92-065F-BAB7-3FED-E7B72B6DC81F}"/>
          </ac:spMkLst>
        </pc:spChg>
        <pc:grpChg chg="mod">
          <ac:chgData name="Scoville, David (NIH/NIEHS) [E]" userId="18f7fb2b-fdd1-4682-8a0d-ccc1081cf1bd" providerId="ADAL" clId="{2858E187-86E0-4B67-9D23-C5381C2891CC}" dt="2025-12-01T14:29:43.081" v="392" actId="14100"/>
          <ac:grpSpMkLst>
            <pc:docMk/>
            <pc:sldMk cId="3706520726" sldId="408"/>
            <ac:grpSpMk id="6" creationId="{97138988-83B2-2C68-7734-058BD1CE846B}"/>
          </ac:grpSpMkLst>
        </pc:grpChg>
      </pc:sldChg>
      <pc:sldChg chg="addSp modSp mod">
        <pc:chgData name="Scoville, David (NIH/NIEHS) [E]" userId="18f7fb2b-fdd1-4682-8a0d-ccc1081cf1bd" providerId="ADAL" clId="{2858E187-86E0-4B67-9D23-C5381C2891CC}" dt="2025-12-01T14:31:07.175" v="461" actId="948"/>
        <pc:sldMkLst>
          <pc:docMk/>
          <pc:sldMk cId="1382366089" sldId="409"/>
        </pc:sldMkLst>
        <pc:spChg chg="add mod">
          <ac:chgData name="Scoville, David (NIH/NIEHS) [E]" userId="18f7fb2b-fdd1-4682-8a0d-ccc1081cf1bd" providerId="ADAL" clId="{2858E187-86E0-4B67-9D23-C5381C2891CC}" dt="2025-12-01T14:31:07.175" v="461" actId="948"/>
          <ac:spMkLst>
            <pc:docMk/>
            <pc:sldMk cId="1382366089" sldId="409"/>
            <ac:spMk id="5" creationId="{FF6CFA03-DE73-0C11-2C93-B64ADEE73E21}"/>
          </ac:spMkLst>
        </pc:spChg>
        <pc:picChg chg="mod">
          <ac:chgData name="Scoville, David (NIH/NIEHS) [E]" userId="18f7fb2b-fdd1-4682-8a0d-ccc1081cf1bd" providerId="ADAL" clId="{2858E187-86E0-4B67-9D23-C5381C2891CC}" dt="2025-12-01T14:28:06.389" v="350" actId="14100"/>
          <ac:picMkLst>
            <pc:docMk/>
            <pc:sldMk cId="1382366089" sldId="409"/>
            <ac:picMk id="4" creationId="{787D9AA9-69F1-7514-273C-75875A40EDB0}"/>
          </ac:picMkLst>
        </pc:picChg>
      </pc:sldChg>
    </pc:docChg>
  </pc:docChgLst>
  <pc:docChgLst>
    <pc:chgData name="Scoville, David (NIH/NIEHS) [E]" userId="18f7fb2b-fdd1-4682-8a0d-ccc1081cf1bd" providerId="ADAL" clId="{B0892B69-2B77-4BCC-9673-BA564576406C}"/>
    <pc:docChg chg="addSld modSld sldOrd">
      <pc:chgData name="Scoville, David (NIH/NIEHS) [E]" userId="18f7fb2b-fdd1-4682-8a0d-ccc1081cf1bd" providerId="ADAL" clId="{B0892B69-2B77-4BCC-9673-BA564576406C}" dt="2025-08-15T20:05:32.283" v="63" actId="20577"/>
      <pc:docMkLst>
        <pc:docMk/>
      </pc:docMkLst>
      <pc:sldChg chg="modSp mod">
        <pc:chgData name="Scoville, David (NIH/NIEHS) [E]" userId="18f7fb2b-fdd1-4682-8a0d-ccc1081cf1bd" providerId="ADAL" clId="{B0892B69-2B77-4BCC-9673-BA564576406C}" dt="2025-08-15T20:05:09.895" v="55" actId="20577"/>
        <pc:sldMkLst>
          <pc:docMk/>
          <pc:sldMk cId="3302397530" sldId="362"/>
        </pc:sldMkLst>
      </pc:sldChg>
      <pc:sldChg chg="modSp mod">
        <pc:chgData name="Scoville, David (NIH/NIEHS) [E]" userId="18f7fb2b-fdd1-4682-8a0d-ccc1081cf1bd" providerId="ADAL" clId="{B0892B69-2B77-4BCC-9673-BA564576406C}" dt="2025-08-15T20:05:16.288" v="57" actId="20577"/>
        <pc:sldMkLst>
          <pc:docMk/>
          <pc:sldMk cId="3891281025" sldId="386"/>
        </pc:sldMkLst>
      </pc:sldChg>
      <pc:sldChg chg="modSp mod">
        <pc:chgData name="Scoville, David (NIH/NIEHS) [E]" userId="18f7fb2b-fdd1-4682-8a0d-ccc1081cf1bd" providerId="ADAL" clId="{B0892B69-2B77-4BCC-9673-BA564576406C}" dt="2025-08-15T20:05:26.784" v="61" actId="20577"/>
        <pc:sldMkLst>
          <pc:docMk/>
          <pc:sldMk cId="248345497" sldId="388"/>
        </pc:sldMkLst>
      </pc:sldChg>
      <pc:sldChg chg="modSp mod">
        <pc:chgData name="Scoville, David (NIH/NIEHS) [E]" userId="18f7fb2b-fdd1-4682-8a0d-ccc1081cf1bd" providerId="ADAL" clId="{B0892B69-2B77-4BCC-9673-BA564576406C}" dt="2025-08-15T20:05:29.832" v="62" actId="20577"/>
        <pc:sldMkLst>
          <pc:docMk/>
          <pc:sldMk cId="3267687131" sldId="389"/>
        </pc:sldMkLst>
      </pc:sldChg>
      <pc:sldChg chg="modSp mod">
        <pc:chgData name="Scoville, David (NIH/NIEHS) [E]" userId="18f7fb2b-fdd1-4682-8a0d-ccc1081cf1bd" providerId="ADAL" clId="{B0892B69-2B77-4BCC-9673-BA564576406C}" dt="2025-08-15T20:05:13.068" v="56" actId="20577"/>
        <pc:sldMkLst>
          <pc:docMk/>
          <pc:sldMk cId="3019216763" sldId="392"/>
        </pc:sldMkLst>
      </pc:sldChg>
      <pc:sldChg chg="modSp mod">
        <pc:chgData name="Scoville, David (NIH/NIEHS) [E]" userId="18f7fb2b-fdd1-4682-8a0d-ccc1081cf1bd" providerId="ADAL" clId="{B0892B69-2B77-4BCC-9673-BA564576406C}" dt="2025-08-15T20:02:46.229" v="50" actId="20577"/>
        <pc:sldMkLst>
          <pc:docMk/>
          <pc:sldMk cId="4162854330" sldId="401"/>
        </pc:sldMkLst>
      </pc:sldChg>
      <pc:sldChg chg="modSp mod">
        <pc:chgData name="Scoville, David (NIH/NIEHS) [E]" userId="18f7fb2b-fdd1-4682-8a0d-ccc1081cf1bd" providerId="ADAL" clId="{B0892B69-2B77-4BCC-9673-BA564576406C}" dt="2025-08-15T20:05:18.943" v="58" actId="20577"/>
        <pc:sldMkLst>
          <pc:docMk/>
          <pc:sldMk cId="2222071772" sldId="404"/>
        </pc:sldMkLst>
      </pc:sldChg>
      <pc:sldChg chg="modSp mod">
        <pc:chgData name="Scoville, David (NIH/NIEHS) [E]" userId="18f7fb2b-fdd1-4682-8a0d-ccc1081cf1bd" providerId="ADAL" clId="{B0892B69-2B77-4BCC-9673-BA564576406C}" dt="2025-08-15T20:05:21.929" v="59" actId="20577"/>
        <pc:sldMkLst>
          <pc:docMk/>
          <pc:sldMk cId="1574866281" sldId="407"/>
        </pc:sldMkLst>
      </pc:sldChg>
      <pc:sldChg chg="modSp mod">
        <pc:chgData name="Scoville, David (NIH/NIEHS) [E]" userId="18f7fb2b-fdd1-4682-8a0d-ccc1081cf1bd" providerId="ADAL" clId="{B0892B69-2B77-4BCC-9673-BA564576406C}" dt="2025-08-15T20:05:24.065" v="60" actId="20577"/>
        <pc:sldMkLst>
          <pc:docMk/>
          <pc:sldMk cId="3706520726" sldId="408"/>
        </pc:sldMkLst>
      </pc:sldChg>
      <pc:sldChg chg="modSp mod">
        <pc:chgData name="Scoville, David (NIH/NIEHS) [E]" userId="18f7fb2b-fdd1-4682-8a0d-ccc1081cf1bd" providerId="ADAL" clId="{B0892B69-2B77-4BCC-9673-BA564576406C}" dt="2025-08-15T20:05:32.283" v="63" actId="20577"/>
        <pc:sldMkLst>
          <pc:docMk/>
          <pc:sldMk cId="1382366089" sldId="409"/>
        </pc:sldMkLst>
      </pc:sldChg>
      <pc:sldChg chg="addSp delSp modSp new mod ord">
        <pc:chgData name="Scoville, David (NIH/NIEHS) [E]" userId="18f7fb2b-fdd1-4682-8a0d-ccc1081cf1bd" providerId="ADAL" clId="{B0892B69-2B77-4BCC-9673-BA564576406C}" dt="2025-08-15T20:05:05.936" v="54" actId="20577"/>
        <pc:sldMkLst>
          <pc:docMk/>
          <pc:sldMk cId="2375239511" sldId="410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74CE4F-98ED-429A-A98B-90896BCA01A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00A25DD-5D4B-45EF-B9E9-F7C24864167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F82276-0D64-4EE5-BF3F-1C0EDF5C86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C2932-B223-46EC-89AB-2EA0D1A0126C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A3F025-F329-40E0-B119-BA53E79CAD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03F347-8170-477C-A7EA-6CDB85DAC0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F83761-1213-4C54-A59B-48C5DC3230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33200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2E2445-1276-4308-AFE4-BE9F83121B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11A5529-C9FD-4106-90D6-ACE74C4DD17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F14AB1-61C4-4670-8CC8-A389FFEA06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C2932-B223-46EC-89AB-2EA0D1A0126C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FCAD61-9AB0-4BFF-A04F-97571D3EAE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8C12C6-D372-4E18-9D79-09E444232D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F83761-1213-4C54-A59B-48C5DC3230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97806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358441A-3316-4CD8-AC78-4FC0D0859FF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DD28327-BD08-4875-B0DF-5CA8C6827CB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8E5200-D515-4E43-80CC-A8EDCEA648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C2932-B223-46EC-89AB-2EA0D1A0126C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78AD45-2F46-4775-B4A5-D1170AF1BD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BD4BC5-878F-4ECE-AAFC-D4CF5ED6C9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F83761-1213-4C54-A59B-48C5DC3230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37271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7A10EC-A4E4-46A9-84F9-3967E5F758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D7B7E3B-35B5-425D-B579-E34430FCFA9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99F72A-DC7D-4CB2-9AC0-748BD3D8CB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C2932-B223-46EC-89AB-2EA0D1A0126C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FFC835-27D5-47CB-8A7A-6455FD2BAE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14047D-AF1F-442B-8356-1AACA0771B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F83761-1213-4C54-A59B-48C5DC3230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03949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C17831-03B2-4FC8-BE0B-587972E860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9D7C370-6AA7-42A4-BE65-9B022D01B8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346B95-56A3-4783-AD89-B08CA5FA35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C2932-B223-46EC-89AB-2EA0D1A0126C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284166-2F2B-4D1E-A32B-8053B0FF68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BF240C-70B1-4E63-882C-92FAE241D2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F83761-1213-4C54-A59B-48C5DC3230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7812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FADDCB-7562-45A0-AB87-18C44FAD03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6A64882-9356-4F31-AC40-D3664235EC0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1F5816B-D9B0-4456-AB63-AB3552A9589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609FAF3-DDD1-45DE-91EF-842A68AEAD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C2932-B223-46EC-89AB-2EA0D1A0126C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94B5065-5944-4714-892A-E5359552D7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C111C5A-472E-414B-9DC2-6A55660D92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F83761-1213-4C54-A59B-48C5DC3230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69864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55C711-31E3-4206-A11F-D6049CA6AB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8C9315B-373A-40DF-870F-C1CF66EF63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6A1383A-3929-465F-B71C-9EC9617A09F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D38F94C-C71E-4095-8184-89E1759FD5B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67A6C72-8C37-4316-A272-E8E755558A5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4F2D3E7-E5C0-4940-A7BB-8AFFC34517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C2932-B223-46EC-89AB-2EA0D1A0126C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3F4DA61-873A-45B2-8423-8D027A4058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8D29D47-8BB4-4C71-8F67-10E6910788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F83761-1213-4C54-A59B-48C5DC3230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82976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5FE125-CEB4-4999-8225-885FEB65A4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8C4BAB9-5D70-4305-9C34-F830591785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C2932-B223-46EC-89AB-2EA0D1A0126C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74CBF7B-A78B-4622-BAD9-01E243227B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53C7721-4255-453F-9404-47F704910F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F83761-1213-4C54-A59B-48C5DC3230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6648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B7F3FD6-EC87-48D8-B049-151705A27E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C2932-B223-46EC-89AB-2EA0D1A0126C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6755BAF-45EF-4C25-B25F-65FA9CC839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F47FC6A-CE72-4823-A163-D900E56E23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F83761-1213-4C54-A59B-48C5DC3230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27622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3DCBD3-F80F-42AD-BF4C-EFB37F6982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767499F-D05B-4DE2-9988-A71D5D05663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CF7C660-528A-4EA5-9B28-AD5305E80F0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9A95878-8372-4152-A91F-46F328E32D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C2932-B223-46EC-89AB-2EA0D1A0126C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D5E4233-35FC-446D-BBA3-F99494D2CB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EA19C56-49C2-4791-9B10-2CEFA0AB02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F83761-1213-4C54-A59B-48C5DC3230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59711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9B4F15-4E0C-4E87-BAA2-25BC89FE58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20B8198-84FC-4F10-BA6E-AE99A8B00F0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50B4F79-48B5-469F-B6BA-953E70CAC9A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64D6FC5-D092-4692-9E1F-318BE58FEB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C2932-B223-46EC-89AB-2EA0D1A0126C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059DE8F-2736-48CA-A3F2-F0CC5A78A8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F3387D1-EF59-421B-A0AD-6CA611208E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F83761-1213-4C54-A59B-48C5DC3230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61480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3D86A59-D4F3-4A96-A977-B4A8E3D8B6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0A7CA30-87D2-4E1D-A757-7E0465BB5A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803E57-EA3A-4944-9545-17EA1D59EB9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1C2932-B223-46EC-89AB-2EA0D1A0126C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743FA3-2328-4F12-B6FF-EBB08E0ACB8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57BB9A-DC9C-4517-B56A-3B31CFA6CA4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F83761-1213-4C54-A59B-48C5DC3230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19417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f"/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tif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6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23982A4-8F4E-62C1-6956-0078A7F4094C}"/>
              </a:ext>
            </a:extLst>
          </p:cNvPr>
          <p:cNvSpPr txBox="1"/>
          <p:nvPr/>
        </p:nvSpPr>
        <p:spPr>
          <a:xfrm>
            <a:off x="6090" y="-6848"/>
            <a:ext cx="12185909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3200" dirty="0">
                <a:latin typeface="Calibri" panose="020F0502020204030204" pitchFamily="34" charset="0"/>
                <a:cs typeface="Calibri" panose="020F0502020204030204" pitchFamily="34" charset="0"/>
              </a:rPr>
              <a:t>Supplemental Figure 1. Read counts and Feature counts across all samples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09A0F2A-CC4E-7FB7-FC25-EF4B3AC65AF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1706" y="1877957"/>
            <a:ext cx="5266487" cy="421318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81637A2B-4EF8-999E-0A06-E5CC2923228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88633" y="1877957"/>
            <a:ext cx="5266487" cy="4213189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3800E4BD-3A19-82B8-A363-A25DA5AC1CEA}"/>
              </a:ext>
            </a:extLst>
          </p:cNvPr>
          <p:cNvSpPr txBox="1"/>
          <p:nvPr/>
        </p:nvSpPr>
        <p:spPr>
          <a:xfrm>
            <a:off x="436880" y="1626024"/>
            <a:ext cx="6347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0A1AB7D-15B3-31F0-861D-46F02A4DFC87}"/>
              </a:ext>
            </a:extLst>
          </p:cNvPr>
          <p:cNvSpPr txBox="1"/>
          <p:nvPr/>
        </p:nvSpPr>
        <p:spPr>
          <a:xfrm>
            <a:off x="6424066" y="1647124"/>
            <a:ext cx="6347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232BE77-78C8-8335-A665-D49DBCB2C290}"/>
              </a:ext>
            </a:extLst>
          </p:cNvPr>
          <p:cNvSpPr txBox="1"/>
          <p:nvPr/>
        </p:nvSpPr>
        <p:spPr>
          <a:xfrm>
            <a:off x="126482" y="5879771"/>
            <a:ext cx="11939035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Aft>
                <a:spcPts val="1000"/>
              </a:spcAft>
            </a:pPr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1. Reads and gene counts for each embryonic sample. (A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Violin plots showing number of reads per cell for all cells passing quality control filters, and</a:t>
            </a:r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B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gene counts per cell for all cells analyzed.</a:t>
            </a:r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628543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8867B836-FD31-D24F-80A2-9908B7BD9574}"/>
              </a:ext>
            </a:extLst>
          </p:cNvPr>
          <p:cNvSpPr txBox="1"/>
          <p:nvPr/>
        </p:nvSpPr>
        <p:spPr>
          <a:xfrm>
            <a:off x="36707" y="-7599"/>
            <a:ext cx="12185909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3200" dirty="0">
                <a:latin typeface="Calibri" panose="020F0502020204030204" pitchFamily="34" charset="0"/>
                <a:cs typeface="Calibri" panose="020F0502020204030204" pitchFamily="34" charset="0"/>
              </a:rPr>
              <a:t>Supplemental Figure 2. Individual analysis of e13.5, e15.5, and e18.5 pancreas confirms reduction in endocrine cell number. 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1713FB96-CC59-EF79-6BAB-2A8B2F6BC8B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89045" y="1316020"/>
            <a:ext cx="3975963" cy="3021732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29FC1CEB-3F25-012B-66F5-C16D498D852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407" y="1355599"/>
            <a:ext cx="3871809" cy="294257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321BE381-40E4-0471-BD3C-46F609EE5E7D}"/>
              </a:ext>
            </a:extLst>
          </p:cNvPr>
          <p:cNvSpPr txBox="1"/>
          <p:nvPr/>
        </p:nvSpPr>
        <p:spPr>
          <a:xfrm>
            <a:off x="109407" y="1040161"/>
            <a:ext cx="38718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e13.5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CDEBA7C-F26F-89F5-6527-7927B8142BA2}"/>
              </a:ext>
            </a:extLst>
          </p:cNvPr>
          <p:cNvSpPr txBox="1"/>
          <p:nvPr/>
        </p:nvSpPr>
        <p:spPr>
          <a:xfrm>
            <a:off x="4089045" y="1040161"/>
            <a:ext cx="40366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e15.5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4C869CB-478F-182A-616A-50EAF5CFA7C5}"/>
              </a:ext>
            </a:extLst>
          </p:cNvPr>
          <p:cNvSpPr txBox="1"/>
          <p:nvPr/>
        </p:nvSpPr>
        <p:spPr>
          <a:xfrm>
            <a:off x="70169" y="6106046"/>
            <a:ext cx="12051661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Aft>
                <a:spcPts val="1000"/>
              </a:spcAft>
            </a:pPr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2. Individual analysis of e13.5, e15.5, and e18.5 pancreas confirms reduction in endocrine cell number. 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UMAP analysis of</a:t>
            </a:r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A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13.5, (</a:t>
            </a:r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e15.5, and</a:t>
            </a:r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C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e18.5 total pancreas, with colors indicating the subpopulations identified. (</a:t>
            </a:r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Quantification of cells in each subcluster. N=3 WT and 3 KO per timepoint, error bars indicate SEM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F3F3BCE-17D3-AA11-B583-7C0CBB222E7C}"/>
              </a:ext>
            </a:extLst>
          </p:cNvPr>
          <p:cNvSpPr txBox="1"/>
          <p:nvPr/>
        </p:nvSpPr>
        <p:spPr>
          <a:xfrm>
            <a:off x="193655" y="1040161"/>
            <a:ext cx="6347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)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D63D17D-D93B-9B61-C595-B3EC61D1D695}"/>
              </a:ext>
            </a:extLst>
          </p:cNvPr>
          <p:cNvSpPr txBox="1"/>
          <p:nvPr/>
        </p:nvSpPr>
        <p:spPr>
          <a:xfrm>
            <a:off x="4215720" y="1040161"/>
            <a:ext cx="6347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)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8B201E7C-D456-5C47-ECAC-833AE85637B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25686" y="1316020"/>
            <a:ext cx="3975963" cy="3021732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E032E14B-1AAF-8983-A9AE-27BF847CE8C5}"/>
              </a:ext>
            </a:extLst>
          </p:cNvPr>
          <p:cNvSpPr txBox="1"/>
          <p:nvPr/>
        </p:nvSpPr>
        <p:spPr>
          <a:xfrm>
            <a:off x="8125686" y="1040161"/>
            <a:ext cx="39569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e18.5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5F8C6B3-A8F6-BC95-6CA3-83928D540993}"/>
              </a:ext>
            </a:extLst>
          </p:cNvPr>
          <p:cNvSpPr txBox="1"/>
          <p:nvPr/>
        </p:nvSpPr>
        <p:spPr>
          <a:xfrm>
            <a:off x="8252361" y="1040161"/>
            <a:ext cx="4179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)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6A391E81-6FAD-225F-3D36-68A302B39D0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78527" y="4172305"/>
            <a:ext cx="3609825" cy="2045911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83ABB738-BC51-4100-70DD-C2242782D71C}"/>
              </a:ext>
            </a:extLst>
          </p:cNvPr>
          <p:cNvSpPr txBox="1"/>
          <p:nvPr/>
        </p:nvSpPr>
        <p:spPr>
          <a:xfrm>
            <a:off x="3580994" y="4214821"/>
            <a:ext cx="6347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)</a:t>
            </a:r>
          </a:p>
        </p:txBody>
      </p:sp>
    </p:spTree>
    <p:extLst>
      <p:ext uri="{BB962C8B-B14F-4D97-AF65-F5344CB8AC3E}">
        <p14:creationId xmlns:p14="http://schemas.microsoft.com/office/powerpoint/2010/main" val="33023975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4DE705-2DD6-F6AC-8E2A-5B8F78CA3E4B}"/>
              </a:ext>
            </a:extLst>
          </p:cNvPr>
          <p:cNvSpPr txBox="1">
            <a:spLocks/>
          </p:cNvSpPr>
          <p:nvPr/>
        </p:nvSpPr>
        <p:spPr>
          <a:xfrm>
            <a:off x="20088" y="-10174"/>
            <a:ext cx="12171912" cy="941494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200" dirty="0">
                <a:latin typeface="Calibri" panose="020F0502020204030204" pitchFamily="34" charset="0"/>
                <a:cs typeface="Calibri" panose="020F0502020204030204" pitchFamily="34" charset="0"/>
              </a:rPr>
              <a:t>Supplemental Figure 3. Embryonic age corresponds with developmental cell stage. 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F1DE374E-3089-E7BE-CDE8-BD5CB299523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2846"/>
          <a:stretch/>
        </p:blipFill>
        <p:spPr>
          <a:xfrm>
            <a:off x="226068" y="1917291"/>
            <a:ext cx="3402036" cy="3897325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C151875D-207B-F12F-E74D-8802BEF35FF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2846"/>
          <a:stretch/>
        </p:blipFill>
        <p:spPr>
          <a:xfrm>
            <a:off x="4230619" y="1917291"/>
            <a:ext cx="3402036" cy="3897325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DA952DB8-3F47-D953-CCBE-F07D6AF9DD8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2846"/>
          <a:stretch/>
        </p:blipFill>
        <p:spPr>
          <a:xfrm>
            <a:off x="8223817" y="1917291"/>
            <a:ext cx="3402037" cy="3897325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3682E5CF-903B-35C9-DD54-625732C30B5B}"/>
              </a:ext>
            </a:extLst>
          </p:cNvPr>
          <p:cNvSpPr txBox="1"/>
          <p:nvPr/>
        </p:nvSpPr>
        <p:spPr>
          <a:xfrm>
            <a:off x="326562" y="1543078"/>
            <a:ext cx="6347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D6E4C38-562C-A635-916B-FE52AF84C1E5}"/>
              </a:ext>
            </a:extLst>
          </p:cNvPr>
          <p:cNvSpPr txBox="1"/>
          <p:nvPr/>
        </p:nvSpPr>
        <p:spPr>
          <a:xfrm>
            <a:off x="4326786" y="1543077"/>
            <a:ext cx="6347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65ED850-5258-73D0-D72A-C8A928F90963}"/>
              </a:ext>
            </a:extLst>
          </p:cNvPr>
          <p:cNvSpPr txBox="1"/>
          <p:nvPr/>
        </p:nvSpPr>
        <p:spPr>
          <a:xfrm>
            <a:off x="8333500" y="1543077"/>
            <a:ext cx="6347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9A3A28A-B87D-A176-DD0A-FE7C09056BCC}"/>
              </a:ext>
            </a:extLst>
          </p:cNvPr>
          <p:cNvSpPr txBox="1"/>
          <p:nvPr/>
        </p:nvSpPr>
        <p:spPr>
          <a:xfrm>
            <a:off x="226067" y="1557748"/>
            <a:ext cx="40045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e13.5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2C2222D-F9A7-D012-012B-25D5DB7D6154}"/>
              </a:ext>
            </a:extLst>
          </p:cNvPr>
          <p:cNvSpPr txBox="1"/>
          <p:nvPr/>
        </p:nvSpPr>
        <p:spPr>
          <a:xfrm>
            <a:off x="4230618" y="1557748"/>
            <a:ext cx="34020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e15.5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F2ABE71-DB7F-EB04-D065-5D2CE3A9DD63}"/>
              </a:ext>
            </a:extLst>
          </p:cNvPr>
          <p:cNvSpPr txBox="1"/>
          <p:nvPr/>
        </p:nvSpPr>
        <p:spPr>
          <a:xfrm>
            <a:off x="8223817" y="1557748"/>
            <a:ext cx="34020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e18.5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B5A8688-6628-43AA-F78D-3556AEE4C4EE}"/>
              </a:ext>
            </a:extLst>
          </p:cNvPr>
          <p:cNvSpPr txBox="1"/>
          <p:nvPr/>
        </p:nvSpPr>
        <p:spPr>
          <a:xfrm>
            <a:off x="4595510" y="2605563"/>
            <a:ext cx="12932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Bipotent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6CCA767-294C-8B2A-E5B3-2715FCA2DE55}"/>
              </a:ext>
            </a:extLst>
          </p:cNvPr>
          <p:cNvSpPr txBox="1"/>
          <p:nvPr/>
        </p:nvSpPr>
        <p:spPr>
          <a:xfrm>
            <a:off x="4549995" y="4183358"/>
            <a:ext cx="14674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/>
              <a:t>ProEndocrine</a:t>
            </a:r>
            <a:endParaRPr lang="en-US" sz="1400" b="1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32D4CEB-A6A3-551D-4CDA-95A080E5B04A}"/>
              </a:ext>
            </a:extLst>
          </p:cNvPr>
          <p:cNvSpPr txBox="1"/>
          <p:nvPr/>
        </p:nvSpPr>
        <p:spPr>
          <a:xfrm>
            <a:off x="5620258" y="4395980"/>
            <a:ext cx="6691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EV+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184717EB-742D-E30B-55B7-01D74CD6A163}"/>
              </a:ext>
            </a:extLst>
          </p:cNvPr>
          <p:cNvSpPr txBox="1"/>
          <p:nvPr/>
        </p:nvSpPr>
        <p:spPr>
          <a:xfrm>
            <a:off x="6052934" y="4621410"/>
            <a:ext cx="8867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/>
              <a:t>PreBeta</a:t>
            </a:r>
            <a:endParaRPr lang="en-US" sz="1400" b="1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047A1C1-5184-AE14-6376-5D51F28C0007}"/>
              </a:ext>
            </a:extLst>
          </p:cNvPr>
          <p:cNvSpPr txBox="1"/>
          <p:nvPr/>
        </p:nvSpPr>
        <p:spPr>
          <a:xfrm>
            <a:off x="7337103" y="4532507"/>
            <a:ext cx="8867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/>
              <a:t>BetaWT</a:t>
            </a:r>
            <a:endParaRPr lang="en-US" sz="1400" b="1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2728AD5-A60B-C1C3-1DC9-4234FA053E6C}"/>
              </a:ext>
            </a:extLst>
          </p:cNvPr>
          <p:cNvSpPr txBox="1"/>
          <p:nvPr/>
        </p:nvSpPr>
        <p:spPr>
          <a:xfrm>
            <a:off x="6723348" y="3865953"/>
            <a:ext cx="8867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/>
              <a:t>BetaKO</a:t>
            </a:r>
            <a:endParaRPr lang="en-US" sz="1400" b="1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1DF0198-AADC-BB92-19FE-2FF291BD04C7}"/>
              </a:ext>
            </a:extLst>
          </p:cNvPr>
          <p:cNvSpPr txBox="1"/>
          <p:nvPr/>
        </p:nvSpPr>
        <p:spPr>
          <a:xfrm>
            <a:off x="6467531" y="3334294"/>
            <a:ext cx="13519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/>
              <a:t>AlphaEpsilon</a:t>
            </a:r>
            <a:endParaRPr lang="en-US" sz="1400" b="1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D1D0EBF0-84D7-1FFC-F42C-06B19AD70393}"/>
              </a:ext>
            </a:extLst>
          </p:cNvPr>
          <p:cNvSpPr txBox="1"/>
          <p:nvPr/>
        </p:nvSpPr>
        <p:spPr>
          <a:xfrm>
            <a:off x="6981584" y="2231803"/>
            <a:ext cx="13519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Alpha2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A3C585ED-D2EF-5FB9-67CF-4D970FD32D56}"/>
              </a:ext>
            </a:extLst>
          </p:cNvPr>
          <p:cNvSpPr txBox="1"/>
          <p:nvPr/>
        </p:nvSpPr>
        <p:spPr>
          <a:xfrm>
            <a:off x="7202240" y="5072828"/>
            <a:ext cx="10396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Unknown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0652E9B9-3EAD-0FB3-5005-3C0A217C425E}"/>
              </a:ext>
            </a:extLst>
          </p:cNvPr>
          <p:cNvSpPr txBox="1"/>
          <p:nvPr/>
        </p:nvSpPr>
        <p:spPr>
          <a:xfrm>
            <a:off x="5106186" y="1880319"/>
            <a:ext cx="12932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Delta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729C0DD7-4FC9-7B47-5BD0-B058F80BF7D4}"/>
              </a:ext>
            </a:extLst>
          </p:cNvPr>
          <p:cNvSpPr txBox="1"/>
          <p:nvPr/>
        </p:nvSpPr>
        <p:spPr>
          <a:xfrm>
            <a:off x="583347" y="2605563"/>
            <a:ext cx="12932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Bipotent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A520A3F-F66E-7176-F3FB-B6A0B4D30CEF}"/>
              </a:ext>
            </a:extLst>
          </p:cNvPr>
          <p:cNvSpPr txBox="1"/>
          <p:nvPr/>
        </p:nvSpPr>
        <p:spPr>
          <a:xfrm>
            <a:off x="537832" y="4183358"/>
            <a:ext cx="14674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/>
              <a:t>ProEndocrine</a:t>
            </a:r>
            <a:endParaRPr lang="en-US" sz="1400" b="1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C75B7C2C-5541-B95A-5A54-430071830939}"/>
              </a:ext>
            </a:extLst>
          </p:cNvPr>
          <p:cNvSpPr txBox="1"/>
          <p:nvPr/>
        </p:nvSpPr>
        <p:spPr>
          <a:xfrm>
            <a:off x="1608095" y="4395980"/>
            <a:ext cx="6691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EV+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0A52EE7C-E235-2DAC-E704-CDC5C5326EC0}"/>
              </a:ext>
            </a:extLst>
          </p:cNvPr>
          <p:cNvSpPr txBox="1"/>
          <p:nvPr/>
        </p:nvSpPr>
        <p:spPr>
          <a:xfrm>
            <a:off x="2031440" y="4621410"/>
            <a:ext cx="8867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/>
              <a:t>PreBeta</a:t>
            </a:r>
            <a:endParaRPr lang="en-US" sz="1400" b="1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A35E86E8-9DB9-2B8F-DC2A-B3182790C5B3}"/>
              </a:ext>
            </a:extLst>
          </p:cNvPr>
          <p:cNvSpPr txBox="1"/>
          <p:nvPr/>
        </p:nvSpPr>
        <p:spPr>
          <a:xfrm>
            <a:off x="3324940" y="4532507"/>
            <a:ext cx="8867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/>
              <a:t>BetaWT</a:t>
            </a:r>
            <a:endParaRPr lang="en-US" sz="1400" b="1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7957E36B-5B37-9F2A-4009-5D3E170E27E9}"/>
              </a:ext>
            </a:extLst>
          </p:cNvPr>
          <p:cNvSpPr txBox="1"/>
          <p:nvPr/>
        </p:nvSpPr>
        <p:spPr>
          <a:xfrm>
            <a:off x="2711185" y="3865953"/>
            <a:ext cx="8867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/>
              <a:t>BetaKO</a:t>
            </a:r>
            <a:endParaRPr lang="en-US" sz="1400" b="1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91F84F15-D161-C08E-7A4C-015A86F15832}"/>
              </a:ext>
            </a:extLst>
          </p:cNvPr>
          <p:cNvSpPr txBox="1"/>
          <p:nvPr/>
        </p:nvSpPr>
        <p:spPr>
          <a:xfrm>
            <a:off x="2455368" y="3334294"/>
            <a:ext cx="13519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/>
              <a:t>AlphaEpsilon</a:t>
            </a:r>
            <a:endParaRPr lang="en-US" sz="1400" b="1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EF2D4F38-BB88-A13A-C8A5-2FEDD22BCD34}"/>
              </a:ext>
            </a:extLst>
          </p:cNvPr>
          <p:cNvSpPr txBox="1"/>
          <p:nvPr/>
        </p:nvSpPr>
        <p:spPr>
          <a:xfrm>
            <a:off x="2969421" y="2231803"/>
            <a:ext cx="13519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Alpha2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F509048-C7B3-F0A3-9FE0-33557295ECAE}"/>
              </a:ext>
            </a:extLst>
          </p:cNvPr>
          <p:cNvSpPr txBox="1"/>
          <p:nvPr/>
        </p:nvSpPr>
        <p:spPr>
          <a:xfrm>
            <a:off x="3190077" y="5072828"/>
            <a:ext cx="10396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Unknown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21A0E585-29D1-1ACF-9FD9-8A72DDFF7D82}"/>
              </a:ext>
            </a:extLst>
          </p:cNvPr>
          <p:cNvSpPr txBox="1"/>
          <p:nvPr/>
        </p:nvSpPr>
        <p:spPr>
          <a:xfrm>
            <a:off x="1094023" y="1880319"/>
            <a:ext cx="12932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Delta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790F846E-83DC-5B69-4D5E-3EC9E05430E2}"/>
              </a:ext>
            </a:extLst>
          </p:cNvPr>
          <p:cNvSpPr txBox="1"/>
          <p:nvPr/>
        </p:nvSpPr>
        <p:spPr>
          <a:xfrm>
            <a:off x="8579687" y="2605563"/>
            <a:ext cx="12932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Bipotent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5FF20586-E80D-0514-4A64-BA958932CDDB}"/>
              </a:ext>
            </a:extLst>
          </p:cNvPr>
          <p:cNvSpPr txBox="1"/>
          <p:nvPr/>
        </p:nvSpPr>
        <p:spPr>
          <a:xfrm>
            <a:off x="8534172" y="4183358"/>
            <a:ext cx="14674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/>
              <a:t>ProEndocrine</a:t>
            </a:r>
            <a:endParaRPr lang="en-US" sz="1400" b="1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5E9E20DD-0BC5-314B-3A04-AC13BEC37BB3}"/>
              </a:ext>
            </a:extLst>
          </p:cNvPr>
          <p:cNvSpPr txBox="1"/>
          <p:nvPr/>
        </p:nvSpPr>
        <p:spPr>
          <a:xfrm>
            <a:off x="9604435" y="4395980"/>
            <a:ext cx="6691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EV+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6ADBA4E-3503-0B1A-5417-2FF963F98948}"/>
              </a:ext>
            </a:extLst>
          </p:cNvPr>
          <p:cNvSpPr txBox="1"/>
          <p:nvPr/>
        </p:nvSpPr>
        <p:spPr>
          <a:xfrm>
            <a:off x="10037111" y="4621410"/>
            <a:ext cx="8867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/>
              <a:t>PreBeta</a:t>
            </a:r>
            <a:endParaRPr lang="en-US" sz="1400" b="1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EC28B23B-4974-265F-90E0-CB8B24966B09}"/>
              </a:ext>
            </a:extLst>
          </p:cNvPr>
          <p:cNvSpPr txBox="1"/>
          <p:nvPr/>
        </p:nvSpPr>
        <p:spPr>
          <a:xfrm>
            <a:off x="11321280" y="4532507"/>
            <a:ext cx="8867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/>
              <a:t>BetaWT</a:t>
            </a:r>
            <a:endParaRPr lang="en-US" sz="1400" b="1" dirty="0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7C0D3B70-8F0A-0347-1296-DA7B2512A8B7}"/>
              </a:ext>
            </a:extLst>
          </p:cNvPr>
          <p:cNvSpPr txBox="1"/>
          <p:nvPr/>
        </p:nvSpPr>
        <p:spPr>
          <a:xfrm>
            <a:off x="10707525" y="3865953"/>
            <a:ext cx="8867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/>
              <a:t>BetaKO</a:t>
            </a:r>
            <a:endParaRPr lang="en-US" sz="1400" b="1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96B600C0-40AF-73BD-0A87-BD4C00E62732}"/>
              </a:ext>
            </a:extLst>
          </p:cNvPr>
          <p:cNvSpPr txBox="1"/>
          <p:nvPr/>
        </p:nvSpPr>
        <p:spPr>
          <a:xfrm>
            <a:off x="10451708" y="3334294"/>
            <a:ext cx="13519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/>
              <a:t>AlphaEpsilon</a:t>
            </a:r>
            <a:endParaRPr lang="en-US" sz="1400" b="1" dirty="0"/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B8712701-6931-F358-3C4F-439915C3015C}"/>
              </a:ext>
            </a:extLst>
          </p:cNvPr>
          <p:cNvSpPr txBox="1"/>
          <p:nvPr/>
        </p:nvSpPr>
        <p:spPr>
          <a:xfrm>
            <a:off x="10965761" y="2231803"/>
            <a:ext cx="13519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Alpha2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38846F75-0565-145C-9900-A9999B9A23AB}"/>
              </a:ext>
            </a:extLst>
          </p:cNvPr>
          <p:cNvSpPr txBox="1"/>
          <p:nvPr/>
        </p:nvSpPr>
        <p:spPr>
          <a:xfrm>
            <a:off x="11186417" y="5072828"/>
            <a:ext cx="10396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Unknown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8D2D7911-9862-6B5A-4967-89A65F9CBCAF}"/>
              </a:ext>
            </a:extLst>
          </p:cNvPr>
          <p:cNvSpPr txBox="1"/>
          <p:nvPr/>
        </p:nvSpPr>
        <p:spPr>
          <a:xfrm>
            <a:off x="9090363" y="1880319"/>
            <a:ext cx="12932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Delt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FB241CB-51CD-D5C1-3FA2-1DDE0455C93D}"/>
              </a:ext>
            </a:extLst>
          </p:cNvPr>
          <p:cNvSpPr txBox="1"/>
          <p:nvPr/>
        </p:nvSpPr>
        <p:spPr>
          <a:xfrm>
            <a:off x="226067" y="5926405"/>
            <a:ext cx="1181585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Aft>
                <a:spcPts val="1000"/>
              </a:spcAft>
            </a:pPr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3. Embryonic age corresponds with developmental cell stage. 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UMAP analysis of individual endocrine subclusters for at (</a:t>
            </a:r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e13.5, (</a:t>
            </a:r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e15.5, and (</a:t>
            </a:r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e18.5 pancreas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220717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439AB2C-C994-5076-7563-5C0765104E6D}"/>
              </a:ext>
            </a:extLst>
          </p:cNvPr>
          <p:cNvSpPr txBox="1"/>
          <p:nvPr/>
        </p:nvSpPr>
        <p:spPr>
          <a:xfrm>
            <a:off x="0" y="0"/>
            <a:ext cx="12192000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3200" dirty="0">
                <a:latin typeface="Calibri" panose="020F0502020204030204" pitchFamily="34" charset="0"/>
                <a:cs typeface="Calibri" panose="020F0502020204030204" pitchFamily="34" charset="0"/>
              </a:rPr>
              <a:t>Supplemental Figure 4. </a:t>
            </a:r>
            <a:r>
              <a:rPr lang="el-GR" sz="3200" dirty="0">
                <a:latin typeface="Calibri" panose="020F0502020204030204" pitchFamily="34" charset="0"/>
                <a:cs typeface="Calibri" panose="020F0502020204030204" pitchFamily="34" charset="0"/>
              </a:rPr>
              <a:t>β</a:t>
            </a:r>
            <a:r>
              <a:rPr lang="en-US" sz="3200" dirty="0">
                <a:latin typeface="Calibri" panose="020F0502020204030204" pitchFamily="34" charset="0"/>
                <a:cs typeface="Calibri" panose="020F0502020204030204" pitchFamily="34" charset="0"/>
              </a:rPr>
              <a:t> cell-like identity of </a:t>
            </a:r>
            <a:r>
              <a:rPr lang="el-GR" sz="3200" dirty="0">
                <a:latin typeface="Calibri" panose="020F0502020204030204" pitchFamily="34" charset="0"/>
                <a:cs typeface="Calibri" panose="020F0502020204030204" pitchFamily="34" charset="0"/>
              </a:rPr>
              <a:t>β</a:t>
            </a:r>
            <a:r>
              <a:rPr lang="en-US" sz="3200" dirty="0">
                <a:latin typeface="Calibri" panose="020F0502020204030204" pitchFamily="34" charset="0"/>
                <a:cs typeface="Calibri" panose="020F0502020204030204" pitchFamily="34" charset="0"/>
              </a:rPr>
              <a:t>KO cells based on expression of </a:t>
            </a:r>
            <a:r>
              <a:rPr lang="el-GR" sz="3200" dirty="0">
                <a:latin typeface="Calibri" panose="020F0502020204030204" pitchFamily="34" charset="0"/>
                <a:cs typeface="Calibri" panose="020F0502020204030204" pitchFamily="34" charset="0"/>
              </a:rPr>
              <a:t>β</a:t>
            </a:r>
            <a:r>
              <a:rPr lang="en-US" sz="3200" dirty="0">
                <a:latin typeface="Calibri" panose="020F0502020204030204" pitchFamily="34" charset="0"/>
                <a:cs typeface="Calibri" panose="020F0502020204030204" pitchFamily="34" charset="0"/>
              </a:rPr>
              <a:t> cell identity genes.</a:t>
            </a: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0737DF2F-BC37-3ED9-AB4E-84191437642B}"/>
              </a:ext>
            </a:extLst>
          </p:cNvPr>
          <p:cNvGrpSpPr/>
          <p:nvPr/>
        </p:nvGrpSpPr>
        <p:grpSpPr>
          <a:xfrm>
            <a:off x="196077" y="1314705"/>
            <a:ext cx="3796847" cy="3859655"/>
            <a:chOff x="196077" y="1859648"/>
            <a:chExt cx="3796847" cy="3859655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CCA414C7-0975-FA8F-CD34-ABB0F890CB3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6077" y="1928106"/>
              <a:ext cx="3796847" cy="3791197"/>
            </a:xfrm>
            <a:prstGeom prst="rect">
              <a:avLst/>
            </a:prstGeom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31FF41CE-40ED-60A0-D87C-E2D603C1A54F}"/>
                </a:ext>
              </a:extLst>
            </p:cNvPr>
            <p:cNvSpPr txBox="1"/>
            <p:nvPr/>
          </p:nvSpPr>
          <p:spPr>
            <a:xfrm>
              <a:off x="1658272" y="1859648"/>
              <a:ext cx="872455" cy="4001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b="1" i="1" dirty="0"/>
                <a:t>Slc2a2</a:t>
              </a:r>
            </a:p>
          </p:txBody>
        </p:sp>
      </p:grpSp>
      <p:grpSp>
        <p:nvGrpSpPr>
          <p:cNvPr id="17" name="Group 16">
            <a:extLst>
              <a:ext uri="{FF2B5EF4-FFF2-40B4-BE49-F238E27FC236}">
                <a16:creationId xmlns:a16="http://schemas.microsoft.com/office/drawing/2014/main" id="{96A2F24D-B5E6-9F07-0B00-6B3019C14450}"/>
              </a:ext>
            </a:extLst>
          </p:cNvPr>
          <p:cNvGrpSpPr/>
          <p:nvPr/>
        </p:nvGrpSpPr>
        <p:grpSpPr>
          <a:xfrm>
            <a:off x="4197576" y="1383163"/>
            <a:ext cx="3796847" cy="3791197"/>
            <a:chOff x="4197576" y="1928106"/>
            <a:chExt cx="3796847" cy="3791197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CADC7E82-3568-66B4-A3E4-DA42C21E5FA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97576" y="1928106"/>
              <a:ext cx="3796847" cy="3791197"/>
            </a:xfrm>
            <a:prstGeom prst="rect">
              <a:avLst/>
            </a:prstGeom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939B4F03-8A2C-8F0E-A08B-FDB146796A4A}"/>
                </a:ext>
              </a:extLst>
            </p:cNvPr>
            <p:cNvSpPr txBox="1"/>
            <p:nvPr/>
          </p:nvSpPr>
          <p:spPr>
            <a:xfrm>
              <a:off x="5666374" y="1928106"/>
              <a:ext cx="872455" cy="4001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b="1" i="1" dirty="0" err="1"/>
                <a:t>Iapp</a:t>
              </a:r>
              <a:endParaRPr lang="en-US" sz="2000" b="1" i="1" dirty="0"/>
            </a:p>
          </p:txBody>
        </p: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F8735F88-643E-70DF-DF5E-AEE187FE1E13}"/>
              </a:ext>
            </a:extLst>
          </p:cNvPr>
          <p:cNvGrpSpPr/>
          <p:nvPr/>
        </p:nvGrpSpPr>
        <p:grpSpPr>
          <a:xfrm>
            <a:off x="8199075" y="1363087"/>
            <a:ext cx="3796847" cy="3811273"/>
            <a:chOff x="8199075" y="1908030"/>
            <a:chExt cx="3796847" cy="3811273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8EBEF374-7F0D-E5F6-04C7-521F3CB92AA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199075" y="1928106"/>
              <a:ext cx="3796847" cy="3791197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29877A14-B32E-DEE4-D5BB-26F59804A0BE}"/>
                </a:ext>
              </a:extLst>
            </p:cNvPr>
            <p:cNvSpPr txBox="1"/>
            <p:nvPr/>
          </p:nvSpPr>
          <p:spPr>
            <a:xfrm>
              <a:off x="9685959" y="1908030"/>
              <a:ext cx="872455" cy="4001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b="1" i="1" dirty="0"/>
                <a:t>G6pc2</a:t>
              </a:r>
            </a:p>
          </p:txBody>
        </p:sp>
      </p:grpSp>
      <p:sp>
        <p:nvSpPr>
          <p:cNvPr id="19" name="TextBox 18">
            <a:extLst>
              <a:ext uri="{FF2B5EF4-FFF2-40B4-BE49-F238E27FC236}">
                <a16:creationId xmlns:a16="http://schemas.microsoft.com/office/drawing/2014/main" id="{2D558487-B285-3284-7BF0-A6C5B1F3BD73}"/>
              </a:ext>
            </a:extLst>
          </p:cNvPr>
          <p:cNvSpPr txBox="1"/>
          <p:nvPr/>
        </p:nvSpPr>
        <p:spPr>
          <a:xfrm>
            <a:off x="196077" y="1372568"/>
            <a:ext cx="6347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248F7B3-B1AF-B045-CC61-E5851660B579}"/>
              </a:ext>
            </a:extLst>
          </p:cNvPr>
          <p:cNvSpPr txBox="1"/>
          <p:nvPr/>
        </p:nvSpPr>
        <p:spPr>
          <a:xfrm>
            <a:off x="4197576" y="1372567"/>
            <a:ext cx="6347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EE97088-EF7C-9486-ECD6-6AB6E3EC0738}"/>
              </a:ext>
            </a:extLst>
          </p:cNvPr>
          <p:cNvSpPr txBox="1"/>
          <p:nvPr/>
        </p:nvSpPr>
        <p:spPr>
          <a:xfrm>
            <a:off x="8199075" y="1372567"/>
            <a:ext cx="6347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F2815F6-B28E-0A95-1444-2492F4007ECC}"/>
              </a:ext>
            </a:extLst>
          </p:cNvPr>
          <p:cNvSpPr txBox="1"/>
          <p:nvPr/>
        </p:nvSpPr>
        <p:spPr>
          <a:xfrm>
            <a:off x="85436" y="5356741"/>
            <a:ext cx="11910485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Aft>
                <a:spcPts val="1000"/>
              </a:spcAft>
            </a:pPr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4. </a:t>
            </a:r>
            <a:r>
              <a:rPr lang="el-GR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β</a:t>
            </a:r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ell-like identity of </a:t>
            </a:r>
            <a:r>
              <a:rPr lang="el-GR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β</a:t>
            </a:r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O cells based on expression of </a:t>
            </a:r>
            <a:r>
              <a:rPr lang="el-GR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β</a:t>
            </a:r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ell identity genes.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UMAP analysis in combined e13.5, e15.5, and e18.5 pancreas samples, both WT and KO cells, for expression of β cell markers (</a:t>
            </a:r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en-US" sz="14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lc2a2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(</a:t>
            </a:r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en-US" sz="1400" i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app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and (</a:t>
            </a:r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en-US" sz="14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6pc2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7486628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C11C6FF-5355-921B-A3AE-17E5677B0CCE}"/>
              </a:ext>
            </a:extLst>
          </p:cNvPr>
          <p:cNvSpPr txBox="1"/>
          <p:nvPr/>
        </p:nvSpPr>
        <p:spPr>
          <a:xfrm>
            <a:off x="0" y="0"/>
            <a:ext cx="12192000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3200" dirty="0">
                <a:latin typeface="Calibri" panose="020F0502020204030204" pitchFamily="34" charset="0"/>
                <a:cs typeface="Calibri" panose="020F0502020204030204" pitchFamily="34" charset="0"/>
              </a:rPr>
              <a:t>Supplemental Figure 5. </a:t>
            </a:r>
            <a:r>
              <a:rPr lang="en-US" sz="3200" i="1" dirty="0" err="1">
                <a:latin typeface="Calibri" panose="020F0502020204030204" pitchFamily="34" charset="0"/>
                <a:cs typeface="Calibri" panose="020F0502020204030204" pitchFamily="34" charset="0"/>
              </a:rPr>
              <a:t>ChgB</a:t>
            </a:r>
            <a:r>
              <a:rPr lang="en-US" sz="3200" dirty="0">
                <a:latin typeface="Calibri" panose="020F0502020204030204" pitchFamily="34" charset="0"/>
                <a:cs typeface="Calibri" panose="020F0502020204030204" pitchFamily="34" charset="0"/>
              </a:rPr>
              <a:t> expression changes during endocrine development.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97138988-83B2-2C68-7734-058BD1CE846B}"/>
              </a:ext>
            </a:extLst>
          </p:cNvPr>
          <p:cNvGrpSpPr>
            <a:grpSpLocks noChangeAspect="1"/>
          </p:cNvGrpSpPr>
          <p:nvPr/>
        </p:nvGrpSpPr>
        <p:grpSpPr>
          <a:xfrm>
            <a:off x="3095047" y="1077218"/>
            <a:ext cx="4434649" cy="4427655"/>
            <a:chOff x="3095047" y="1077218"/>
            <a:chExt cx="5260468" cy="5252171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9AC557D5-1447-73F3-3D87-4E632498B10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95047" y="1077218"/>
              <a:ext cx="5260468" cy="5252171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6874B5C2-C011-2F1D-C0AD-DC57F5AC1D55}"/>
                </a:ext>
              </a:extLst>
            </p:cNvPr>
            <p:cNvSpPr txBox="1"/>
            <p:nvPr/>
          </p:nvSpPr>
          <p:spPr>
            <a:xfrm>
              <a:off x="4874738" y="1077218"/>
              <a:ext cx="872455" cy="40010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b="1" i="1" dirty="0"/>
                <a:t>Chgb</a:t>
              </a:r>
            </a:p>
          </p:txBody>
        </p: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7922FF92-065F-BAB7-3FED-E7B72B6DC81F}"/>
              </a:ext>
            </a:extLst>
          </p:cNvPr>
          <p:cNvSpPr txBox="1"/>
          <p:nvPr/>
        </p:nvSpPr>
        <p:spPr>
          <a:xfrm>
            <a:off x="207818" y="5504873"/>
            <a:ext cx="11776363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Aft>
                <a:spcPts val="1000"/>
              </a:spcAft>
            </a:pPr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5. </a:t>
            </a:r>
            <a:r>
              <a:rPr lang="en-US" sz="1400" b="1" i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hgB</a:t>
            </a:r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xpression remains elevated in </a:t>
            </a:r>
            <a:r>
              <a:rPr lang="el-GR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β</a:t>
            </a:r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O cells. 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iolin plots show the dynamic expression of </a:t>
            </a:r>
            <a:r>
              <a:rPr lang="en-US" sz="1400" i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hgB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during endocrine development. 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0652072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439AB2C-C994-5076-7563-5C0765104E6D}"/>
              </a:ext>
            </a:extLst>
          </p:cNvPr>
          <p:cNvSpPr txBox="1"/>
          <p:nvPr/>
        </p:nvSpPr>
        <p:spPr>
          <a:xfrm>
            <a:off x="0" y="0"/>
            <a:ext cx="121920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3200" dirty="0">
                <a:latin typeface="Calibri" panose="020F0502020204030204" pitchFamily="34" charset="0"/>
                <a:cs typeface="Calibri" panose="020F0502020204030204" pitchFamily="34" charset="0"/>
              </a:rPr>
              <a:t>Supplemental Figure 6. </a:t>
            </a:r>
            <a:r>
              <a:rPr lang="en-US" sz="3200" i="1" dirty="0">
                <a:latin typeface="Calibri" panose="020F0502020204030204" pitchFamily="34" charset="0"/>
                <a:cs typeface="Calibri" panose="020F0502020204030204" pitchFamily="34" charset="0"/>
              </a:rPr>
              <a:t>Glis3</a:t>
            </a:r>
            <a:r>
              <a:rPr lang="en-US" sz="3200" dirty="0">
                <a:latin typeface="Calibri" panose="020F0502020204030204" pitchFamily="34" charset="0"/>
                <a:cs typeface="Calibri" panose="020F0502020204030204" pitchFamily="34" charset="0"/>
              </a:rPr>
              <a:t> expression in scRNA-seq pancreas.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D558487-B285-3284-7BF0-A6C5B1F3BD73}"/>
              </a:ext>
            </a:extLst>
          </p:cNvPr>
          <p:cNvSpPr txBox="1"/>
          <p:nvPr/>
        </p:nvSpPr>
        <p:spPr>
          <a:xfrm>
            <a:off x="406804" y="908012"/>
            <a:ext cx="4614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)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0284AA9F-1F0E-893F-CC0A-2310C09C5841}"/>
              </a:ext>
            </a:extLst>
          </p:cNvPr>
          <p:cNvGrpSpPr>
            <a:grpSpLocks noChangeAspect="1"/>
          </p:cNvGrpSpPr>
          <p:nvPr/>
        </p:nvGrpSpPr>
        <p:grpSpPr>
          <a:xfrm>
            <a:off x="139957" y="900112"/>
            <a:ext cx="3746173" cy="3631486"/>
            <a:chOff x="3831373" y="1088559"/>
            <a:chExt cx="5156480" cy="4998616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C60781D6-EAD1-EDDC-FC6E-41A2ADA9316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80" t="11301" r="3829" b="4453"/>
            <a:stretch/>
          </p:blipFill>
          <p:spPr>
            <a:xfrm>
              <a:off x="3831373" y="1571005"/>
              <a:ext cx="5156480" cy="4516170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097E109A-719D-38D0-6C94-EE1A79580E63}"/>
                </a:ext>
              </a:extLst>
            </p:cNvPr>
            <p:cNvSpPr txBox="1"/>
            <p:nvPr/>
          </p:nvSpPr>
          <p:spPr>
            <a:xfrm>
              <a:off x="5951965" y="1088559"/>
              <a:ext cx="1011543" cy="55073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b="1" i="1" dirty="0"/>
                <a:t>Glis3</a:t>
              </a:r>
            </a:p>
          </p:txBody>
        </p:sp>
      </p:grpSp>
      <p:grpSp>
        <p:nvGrpSpPr>
          <p:cNvPr id="8" name="Group 7">
            <a:extLst>
              <a:ext uri="{FF2B5EF4-FFF2-40B4-BE49-F238E27FC236}">
                <a16:creationId xmlns:a16="http://schemas.microsoft.com/office/drawing/2014/main" id="{5A3B56B0-41FB-8DC9-BA60-CB3ACAA8DBDE}"/>
              </a:ext>
            </a:extLst>
          </p:cNvPr>
          <p:cNvGrpSpPr>
            <a:grpSpLocks noChangeAspect="1"/>
          </p:cNvGrpSpPr>
          <p:nvPr/>
        </p:nvGrpSpPr>
        <p:grpSpPr>
          <a:xfrm>
            <a:off x="4211329" y="908012"/>
            <a:ext cx="3549605" cy="3660910"/>
            <a:chOff x="681718" y="1008635"/>
            <a:chExt cx="4885911" cy="5039118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2B04E548-BDF9-857D-2956-5406BC70792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81718" y="1169549"/>
              <a:ext cx="4885911" cy="4878204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0861D1E3-E869-C2B0-0F29-A05EFA2A6E3D}"/>
                </a:ext>
              </a:extLst>
            </p:cNvPr>
            <p:cNvSpPr txBox="1"/>
            <p:nvPr/>
          </p:nvSpPr>
          <p:spPr>
            <a:xfrm>
              <a:off x="2727554" y="1008635"/>
              <a:ext cx="1060690" cy="52899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b="1" i="1" dirty="0"/>
                <a:t>Glis3</a:t>
              </a:r>
            </a:p>
          </p:txBody>
        </p: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id="{8E5CCBAE-1397-7C0F-7E68-FF33C408A341}"/>
              </a:ext>
            </a:extLst>
          </p:cNvPr>
          <p:cNvGrpSpPr>
            <a:grpSpLocks noChangeAspect="1"/>
          </p:cNvGrpSpPr>
          <p:nvPr/>
        </p:nvGrpSpPr>
        <p:grpSpPr>
          <a:xfrm>
            <a:off x="7980506" y="887361"/>
            <a:ext cx="4085017" cy="4171984"/>
            <a:chOff x="6363669" y="1002135"/>
            <a:chExt cx="5622887" cy="5742593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0A8C3519-559B-24AF-D293-879FCBBE588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363669" y="1130710"/>
              <a:ext cx="5622887" cy="5614018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49B95C1F-F5BD-FB49-5706-3EEAC7E3DE4F}"/>
                </a:ext>
              </a:extLst>
            </p:cNvPr>
            <p:cNvSpPr txBox="1"/>
            <p:nvPr/>
          </p:nvSpPr>
          <p:spPr>
            <a:xfrm>
              <a:off x="8027900" y="1002135"/>
              <a:ext cx="1096896" cy="55073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b="1" i="1" dirty="0"/>
                <a:t>Glis3</a:t>
              </a:r>
            </a:p>
          </p:txBody>
        </p:sp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2D558487-B285-3284-7BF0-A6C5B1F3BD73}"/>
              </a:ext>
            </a:extLst>
          </p:cNvPr>
          <p:cNvSpPr txBox="1"/>
          <p:nvPr/>
        </p:nvSpPr>
        <p:spPr>
          <a:xfrm>
            <a:off x="4494510" y="908012"/>
            <a:ext cx="4614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B8D6822-5A13-1354-C7C9-4401233CCAD2}"/>
              </a:ext>
            </a:extLst>
          </p:cNvPr>
          <p:cNvSpPr txBox="1"/>
          <p:nvPr/>
        </p:nvSpPr>
        <p:spPr>
          <a:xfrm>
            <a:off x="8104137" y="908012"/>
            <a:ext cx="4614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CEEAB98-0AF7-D9FA-CCB4-AEC8C2D6EDE5}"/>
              </a:ext>
            </a:extLst>
          </p:cNvPr>
          <p:cNvSpPr txBox="1"/>
          <p:nvPr/>
        </p:nvSpPr>
        <p:spPr>
          <a:xfrm>
            <a:off x="-1" y="4874194"/>
            <a:ext cx="12065523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Aft>
                <a:spcPts val="1000"/>
              </a:spcAft>
            </a:pPr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6. ScRNA-Seq analysis of </a:t>
            </a:r>
            <a:r>
              <a:rPr lang="en-US" sz="1400" b="1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lis3 </a:t>
            </a:r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xpression during  pancreatic endocrine development.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UMAP analysis of </a:t>
            </a:r>
            <a:r>
              <a:rPr lang="en-US" sz="14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lis3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xpression was performed on combined e13.5, e15.5, and e18.5 pancreas samples from both WT and KO mice. (</a:t>
            </a:r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UMAP comparing </a:t>
            </a:r>
            <a:r>
              <a:rPr lang="en-US" sz="14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lis3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xpression in all pancreatic cell types. (</a:t>
            </a:r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UMAP showing </a:t>
            </a:r>
            <a:r>
              <a:rPr lang="en-US" sz="14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lis3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xpression within various endocrine cell clusters. (</a:t>
            </a:r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Violin plots quantifying </a:t>
            </a:r>
            <a:r>
              <a:rPr lang="en-US" sz="14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lis3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xpression in each of the endocrine subpopulations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834549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0226D3F-3DE4-ABD2-873E-7D0C287927F3}"/>
              </a:ext>
            </a:extLst>
          </p:cNvPr>
          <p:cNvSpPr txBox="1"/>
          <p:nvPr/>
        </p:nvSpPr>
        <p:spPr>
          <a:xfrm>
            <a:off x="0" y="0"/>
            <a:ext cx="12192000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3200">
                <a:latin typeface="Calibri" panose="020F0502020204030204" pitchFamily="34" charset="0"/>
                <a:cs typeface="Calibri" panose="020F0502020204030204" pitchFamily="34" charset="0"/>
              </a:rPr>
              <a:t>Supplemental </a:t>
            </a:r>
            <a:r>
              <a:rPr lang="en-US" sz="3200" dirty="0">
                <a:latin typeface="Calibri" panose="020F0502020204030204" pitchFamily="34" charset="0"/>
                <a:cs typeface="Calibri" panose="020F0502020204030204" pitchFamily="34" charset="0"/>
              </a:rPr>
              <a:t>Figure 7. SnATAC-seq of WT and </a:t>
            </a:r>
            <a:r>
              <a:rPr lang="en-US" sz="3200" i="1" dirty="0">
                <a:latin typeface="Calibri" panose="020F0502020204030204" pitchFamily="34" charset="0"/>
                <a:cs typeface="Calibri" panose="020F0502020204030204" pitchFamily="34" charset="0"/>
              </a:rPr>
              <a:t>Glis3</a:t>
            </a:r>
            <a:r>
              <a:rPr lang="en-US" sz="3200" dirty="0">
                <a:latin typeface="Calibri" panose="020F0502020204030204" pitchFamily="34" charset="0"/>
                <a:cs typeface="Calibri" panose="020F0502020204030204" pitchFamily="34" charset="0"/>
              </a:rPr>
              <a:t>KO mice separated by genotype 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787D9AA9-69F1-7514-273C-75875A40EDB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14439" y="1239470"/>
            <a:ext cx="4685359" cy="401602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F6CFA03-DE73-0C11-2C93-B64ADEE73E21}"/>
              </a:ext>
            </a:extLst>
          </p:cNvPr>
          <p:cNvSpPr txBox="1"/>
          <p:nvPr/>
        </p:nvSpPr>
        <p:spPr>
          <a:xfrm>
            <a:off x="159326" y="5255491"/>
            <a:ext cx="11866419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Aft>
                <a:spcPts val="1000"/>
              </a:spcAft>
            </a:pPr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7. SnATAC-seq of WT and </a:t>
            </a:r>
            <a:r>
              <a:rPr lang="en-US" sz="1400" b="1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lis3</a:t>
            </a:r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O mice separated by genotype.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UMAP analysis of the endocrine subcluster from snATAC-seq data at e15.5. Genotype is indicated by color, with yellow representing KO and blue representing WT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823660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7219</TotalTime>
  <Words>538</Words>
  <Application>Microsoft Office PowerPoint</Application>
  <PresentationFormat>Widescreen</PresentationFormat>
  <Paragraphs>72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Update</dc:title>
  <dc:creator>Scoville, David (NIH/NIEHS) [E]</dc:creator>
  <cp:lastModifiedBy>Scoville, David (NIH/NIEHS) [E]</cp:lastModifiedBy>
  <cp:revision>88</cp:revision>
  <dcterms:created xsi:type="dcterms:W3CDTF">2022-11-15T19:00:30Z</dcterms:created>
  <dcterms:modified xsi:type="dcterms:W3CDTF">2025-12-01T14:31:11Z</dcterms:modified>
</cp:coreProperties>
</file>